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575" r:id="rId2"/>
    <p:sldId id="558" r:id="rId3"/>
    <p:sldId id="560" r:id="rId4"/>
    <p:sldId id="573" r:id="rId5"/>
    <p:sldId id="578" r:id="rId6"/>
    <p:sldId id="589" r:id="rId7"/>
    <p:sldId id="590" r:id="rId8"/>
    <p:sldId id="591" r:id="rId9"/>
    <p:sldId id="592" r:id="rId10"/>
    <p:sldId id="593" r:id="rId11"/>
    <p:sldId id="594" r:id="rId1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enny Wilson" initials="KW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7DE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01" autoAdjust="0"/>
    <p:restoredTop sz="96400" autoAdjust="0"/>
  </p:normalViewPr>
  <p:slideViewPr>
    <p:cSldViewPr>
      <p:cViewPr varScale="1">
        <p:scale>
          <a:sx n="103" d="100"/>
          <a:sy n="103" d="100"/>
        </p:scale>
        <p:origin x="1830" y="12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-22-23%20Canton%20S%20and%20w1118%20Choline%20and%20Histidine%20Lifespan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LSdata%20Extract%20and%20CoxPH%20Scripts\2n3-23%20Combined%20Canton%20S%20and%20w1118%20Drug%20Lifespan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yler\Dropbox\Tyler\USC-Buck%20Program\Brem's%20Lab\PK's%20Lab\DGRP%20Metabolite%20and%20Phenotype%20Modeling\6-24-23%20Canton%20S%20and%20w1118%20DR+Metabolite%20Lifespans%20-%20Final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chemeClr val="tx1"/>
                </a:solidFill>
              </a:rPr>
              <a:t>Canton S Males</a:t>
            </a:r>
            <a:r>
              <a:rPr lang="en-US" baseline="0">
                <a:solidFill>
                  <a:schemeClr val="tx1"/>
                </a:solidFill>
              </a:rPr>
              <a:t> + Choline Lifespan</a:t>
            </a:r>
            <a:endParaRPr lang="en-US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Male + Chol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anton S Male + Chol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Choline'!$B$72:$AE$72</c:f>
              <c:numCache>
                <c:formatCode>General</c:formatCode>
                <c:ptCount val="3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9.468085106382972</c:v>
                </c:pt>
                <c:pt idx="4">
                  <c:v>99.468085106382972</c:v>
                </c:pt>
                <c:pt idx="5">
                  <c:v>98.936170212765958</c:v>
                </c:pt>
                <c:pt idx="6">
                  <c:v>98.936170212765958</c:v>
                </c:pt>
                <c:pt idx="7">
                  <c:v>98.40425531914893</c:v>
                </c:pt>
                <c:pt idx="8">
                  <c:v>97.872340425531917</c:v>
                </c:pt>
                <c:pt idx="9">
                  <c:v>96.276595744680847</c:v>
                </c:pt>
                <c:pt idx="10">
                  <c:v>95.744680851063833</c:v>
                </c:pt>
                <c:pt idx="11">
                  <c:v>95.744680851063833</c:v>
                </c:pt>
                <c:pt idx="12">
                  <c:v>94.680851063829792</c:v>
                </c:pt>
                <c:pt idx="13">
                  <c:v>91.489361702127667</c:v>
                </c:pt>
                <c:pt idx="14">
                  <c:v>85.106382978723403</c:v>
                </c:pt>
                <c:pt idx="15">
                  <c:v>82.446808510638306</c:v>
                </c:pt>
                <c:pt idx="16">
                  <c:v>78.723404255319153</c:v>
                </c:pt>
                <c:pt idx="17">
                  <c:v>65.425531914893611</c:v>
                </c:pt>
                <c:pt idx="18">
                  <c:v>55.851063829787236</c:v>
                </c:pt>
                <c:pt idx="19">
                  <c:v>49.468085106382972</c:v>
                </c:pt>
                <c:pt idx="20">
                  <c:v>33.510638297872347</c:v>
                </c:pt>
                <c:pt idx="21">
                  <c:v>21.808510638297875</c:v>
                </c:pt>
                <c:pt idx="22">
                  <c:v>19.680851063829792</c:v>
                </c:pt>
                <c:pt idx="23">
                  <c:v>14.893617021276597</c:v>
                </c:pt>
                <c:pt idx="24">
                  <c:v>8.5106382978723474</c:v>
                </c:pt>
                <c:pt idx="25">
                  <c:v>6.3829787234042499</c:v>
                </c:pt>
                <c:pt idx="26">
                  <c:v>3.7234042553191529</c:v>
                </c:pt>
                <c:pt idx="27">
                  <c:v>3.7234042553191529</c:v>
                </c:pt>
                <c:pt idx="28">
                  <c:v>1.5957446808510696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8A9-4C6C-852E-161B359624CE}"/>
            </c:ext>
          </c:extLst>
        </c:ser>
        <c:ser>
          <c:idx val="1"/>
          <c:order val="1"/>
          <c:tx>
            <c:strRef>
              <c:f>'Canton S Male + Chol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Male + Chol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Choline'!$B$73:$AE$73</c:f>
              <c:numCache>
                <c:formatCode>General</c:formatCode>
                <c:ptCount val="30"/>
                <c:pt idx="0">
                  <c:v>100</c:v>
                </c:pt>
                <c:pt idx="1">
                  <c:v>98.5</c:v>
                </c:pt>
                <c:pt idx="2">
                  <c:v>98.5</c:v>
                </c:pt>
                <c:pt idx="3">
                  <c:v>97.5</c:v>
                </c:pt>
                <c:pt idx="4">
                  <c:v>97.5</c:v>
                </c:pt>
                <c:pt idx="5">
                  <c:v>97</c:v>
                </c:pt>
                <c:pt idx="6">
                  <c:v>97</c:v>
                </c:pt>
                <c:pt idx="7">
                  <c:v>96</c:v>
                </c:pt>
                <c:pt idx="8">
                  <c:v>94</c:v>
                </c:pt>
                <c:pt idx="9">
                  <c:v>92.5</c:v>
                </c:pt>
                <c:pt idx="10">
                  <c:v>91.5</c:v>
                </c:pt>
                <c:pt idx="11">
                  <c:v>89</c:v>
                </c:pt>
                <c:pt idx="12">
                  <c:v>86</c:v>
                </c:pt>
                <c:pt idx="13">
                  <c:v>85</c:v>
                </c:pt>
                <c:pt idx="14">
                  <c:v>76.5</c:v>
                </c:pt>
                <c:pt idx="15">
                  <c:v>71</c:v>
                </c:pt>
                <c:pt idx="16">
                  <c:v>66</c:v>
                </c:pt>
                <c:pt idx="17">
                  <c:v>53</c:v>
                </c:pt>
                <c:pt idx="18">
                  <c:v>47</c:v>
                </c:pt>
                <c:pt idx="19">
                  <c:v>42.000000000000007</c:v>
                </c:pt>
                <c:pt idx="20">
                  <c:v>30</c:v>
                </c:pt>
                <c:pt idx="21">
                  <c:v>24</c:v>
                </c:pt>
                <c:pt idx="22">
                  <c:v>19</c:v>
                </c:pt>
                <c:pt idx="23">
                  <c:v>12.5</c:v>
                </c:pt>
                <c:pt idx="24">
                  <c:v>7</c:v>
                </c:pt>
                <c:pt idx="25">
                  <c:v>3.5</c:v>
                </c:pt>
                <c:pt idx="26">
                  <c:v>1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A9-4C6C-852E-161B359624CE}"/>
            </c:ext>
          </c:extLst>
        </c:ser>
        <c:ser>
          <c:idx val="2"/>
          <c:order val="2"/>
          <c:tx>
            <c:strRef>
              <c:f>'Canton S Male + Chol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Canton S Male + Chol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Choline'!$B$74:$AE$74</c:f>
              <c:numCache>
                <c:formatCode>General</c:formatCode>
                <c:ptCount val="30"/>
                <c:pt idx="0">
                  <c:v>100</c:v>
                </c:pt>
                <c:pt idx="1">
                  <c:v>99.492385786802032</c:v>
                </c:pt>
                <c:pt idx="2">
                  <c:v>99.492385786802032</c:v>
                </c:pt>
                <c:pt idx="3">
                  <c:v>98.477157360406096</c:v>
                </c:pt>
                <c:pt idx="4">
                  <c:v>97.969543147208128</c:v>
                </c:pt>
                <c:pt idx="5">
                  <c:v>96.954314720812178</c:v>
                </c:pt>
                <c:pt idx="6">
                  <c:v>96.44670050761421</c:v>
                </c:pt>
                <c:pt idx="7">
                  <c:v>95.939086294416242</c:v>
                </c:pt>
                <c:pt idx="8">
                  <c:v>94.923857868020306</c:v>
                </c:pt>
                <c:pt idx="9">
                  <c:v>93.90862944162437</c:v>
                </c:pt>
                <c:pt idx="10">
                  <c:v>93.401015228426388</c:v>
                </c:pt>
                <c:pt idx="11">
                  <c:v>91.370558375634516</c:v>
                </c:pt>
                <c:pt idx="12">
                  <c:v>88.832487309644677</c:v>
                </c:pt>
                <c:pt idx="13">
                  <c:v>87.817258883248726</c:v>
                </c:pt>
                <c:pt idx="14">
                  <c:v>83.248730964467001</c:v>
                </c:pt>
                <c:pt idx="15">
                  <c:v>72.081218274111677</c:v>
                </c:pt>
                <c:pt idx="16">
                  <c:v>69.035532994923855</c:v>
                </c:pt>
                <c:pt idx="17">
                  <c:v>61.92893401015229</c:v>
                </c:pt>
                <c:pt idx="18">
                  <c:v>55.329949238578678</c:v>
                </c:pt>
                <c:pt idx="19">
                  <c:v>43.147208121827404</c:v>
                </c:pt>
                <c:pt idx="20">
                  <c:v>30.964467005076145</c:v>
                </c:pt>
                <c:pt idx="21">
                  <c:v>26.395939086294419</c:v>
                </c:pt>
                <c:pt idx="22">
                  <c:v>22.335025380710661</c:v>
                </c:pt>
                <c:pt idx="23">
                  <c:v>15.736040609137063</c:v>
                </c:pt>
                <c:pt idx="24">
                  <c:v>8.6294416243654837</c:v>
                </c:pt>
                <c:pt idx="25">
                  <c:v>4.0609137055837579</c:v>
                </c:pt>
                <c:pt idx="26">
                  <c:v>2.0304568527918718</c:v>
                </c:pt>
                <c:pt idx="27">
                  <c:v>1.0152284263959359</c:v>
                </c:pt>
                <c:pt idx="28">
                  <c:v>0.50761421319796796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8A9-4C6C-852E-161B359624CE}"/>
            </c:ext>
          </c:extLst>
        </c:ser>
        <c:ser>
          <c:idx val="3"/>
          <c:order val="3"/>
          <c:tx>
            <c:strRef>
              <c:f>'Canton S Male + Chol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Canton S Male + Chol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Choline'!$B$75:$AE$75</c:f>
              <c:numCache>
                <c:formatCode>General</c:formatCode>
                <c:ptCount val="30"/>
                <c:pt idx="0">
                  <c:v>100</c:v>
                </c:pt>
                <c:pt idx="1">
                  <c:v>99.5</c:v>
                </c:pt>
                <c:pt idx="2">
                  <c:v>96.5</c:v>
                </c:pt>
                <c:pt idx="3">
                  <c:v>96.5</c:v>
                </c:pt>
                <c:pt idx="4">
                  <c:v>96.5</c:v>
                </c:pt>
                <c:pt idx="5">
                  <c:v>96.5</c:v>
                </c:pt>
                <c:pt idx="6">
                  <c:v>95.5</c:v>
                </c:pt>
                <c:pt idx="7">
                  <c:v>95.5</c:v>
                </c:pt>
                <c:pt idx="8">
                  <c:v>95.5</c:v>
                </c:pt>
                <c:pt idx="9">
                  <c:v>94</c:v>
                </c:pt>
                <c:pt idx="10">
                  <c:v>93.5</c:v>
                </c:pt>
                <c:pt idx="11">
                  <c:v>90</c:v>
                </c:pt>
                <c:pt idx="12">
                  <c:v>88</c:v>
                </c:pt>
                <c:pt idx="13">
                  <c:v>86</c:v>
                </c:pt>
                <c:pt idx="14">
                  <c:v>77.5</c:v>
                </c:pt>
                <c:pt idx="15">
                  <c:v>71</c:v>
                </c:pt>
                <c:pt idx="16">
                  <c:v>66</c:v>
                </c:pt>
                <c:pt idx="17">
                  <c:v>58</c:v>
                </c:pt>
                <c:pt idx="18">
                  <c:v>39</c:v>
                </c:pt>
                <c:pt idx="19">
                  <c:v>34.5</c:v>
                </c:pt>
                <c:pt idx="20">
                  <c:v>27.5</c:v>
                </c:pt>
                <c:pt idx="21">
                  <c:v>20.5</c:v>
                </c:pt>
                <c:pt idx="22">
                  <c:v>17</c:v>
                </c:pt>
                <c:pt idx="23">
                  <c:v>7.5</c:v>
                </c:pt>
                <c:pt idx="24">
                  <c:v>5.5</c:v>
                </c:pt>
                <c:pt idx="25">
                  <c:v>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8A9-4C6C-852E-161B359624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solidFill>
                      <a:schemeClr val="tx1"/>
                    </a:solidFill>
                  </a:rPr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solidFill>
                      <a:schemeClr val="tx1"/>
                    </a:solidFill>
                  </a:rPr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anton S Males + Threon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M Threonin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cat>
            <c:numRef>
              <c:f>'Canton S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Threonine'!$B$72:$AF$72</c:f>
              <c:numCache>
                <c:formatCode>General</c:formatCode>
                <c:ptCount val="31"/>
                <c:pt idx="0">
                  <c:v>100</c:v>
                </c:pt>
                <c:pt idx="1">
                  <c:v>98.5</c:v>
                </c:pt>
                <c:pt idx="2">
                  <c:v>97.5</c:v>
                </c:pt>
                <c:pt idx="3">
                  <c:v>97</c:v>
                </c:pt>
                <c:pt idx="4">
                  <c:v>97</c:v>
                </c:pt>
                <c:pt idx="5">
                  <c:v>94.5</c:v>
                </c:pt>
                <c:pt idx="6">
                  <c:v>93</c:v>
                </c:pt>
                <c:pt idx="7">
                  <c:v>93</c:v>
                </c:pt>
                <c:pt idx="8">
                  <c:v>93</c:v>
                </c:pt>
                <c:pt idx="9">
                  <c:v>92.5</c:v>
                </c:pt>
                <c:pt idx="10">
                  <c:v>91.5</c:v>
                </c:pt>
                <c:pt idx="11">
                  <c:v>90</c:v>
                </c:pt>
                <c:pt idx="12">
                  <c:v>88</c:v>
                </c:pt>
                <c:pt idx="13">
                  <c:v>86</c:v>
                </c:pt>
                <c:pt idx="14">
                  <c:v>83</c:v>
                </c:pt>
                <c:pt idx="15">
                  <c:v>80</c:v>
                </c:pt>
                <c:pt idx="16">
                  <c:v>79.5</c:v>
                </c:pt>
                <c:pt idx="17">
                  <c:v>69</c:v>
                </c:pt>
                <c:pt idx="18">
                  <c:v>62.5</c:v>
                </c:pt>
                <c:pt idx="19">
                  <c:v>56.5</c:v>
                </c:pt>
                <c:pt idx="20">
                  <c:v>51.5</c:v>
                </c:pt>
                <c:pt idx="21">
                  <c:v>45.499999999999993</c:v>
                </c:pt>
                <c:pt idx="22">
                  <c:v>40</c:v>
                </c:pt>
                <c:pt idx="23">
                  <c:v>32.5</c:v>
                </c:pt>
                <c:pt idx="24">
                  <c:v>24.5</c:v>
                </c:pt>
                <c:pt idx="25">
                  <c:v>20</c:v>
                </c:pt>
                <c:pt idx="26">
                  <c:v>16</c:v>
                </c:pt>
                <c:pt idx="27">
                  <c:v>11.5</c:v>
                </c:pt>
                <c:pt idx="28">
                  <c:v>6</c:v>
                </c:pt>
                <c:pt idx="29">
                  <c:v>1</c:v>
                </c:pt>
                <c:pt idx="3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D3A-423E-ACFB-18A4CFF3F425}"/>
            </c:ext>
          </c:extLst>
        </c:ser>
        <c:ser>
          <c:idx val="1"/>
          <c:order val="1"/>
          <c:tx>
            <c:strRef>
              <c:f>'Canton S M Threonin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Canton S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Threonine'!$B$73:$AJ$73</c:f>
              <c:numCache>
                <c:formatCode>General</c:formatCode>
                <c:ptCount val="35"/>
                <c:pt idx="0">
                  <c:v>100</c:v>
                </c:pt>
                <c:pt idx="1">
                  <c:v>99</c:v>
                </c:pt>
                <c:pt idx="2">
                  <c:v>99</c:v>
                </c:pt>
                <c:pt idx="3">
                  <c:v>99</c:v>
                </c:pt>
                <c:pt idx="4">
                  <c:v>99</c:v>
                </c:pt>
                <c:pt idx="5">
                  <c:v>99</c:v>
                </c:pt>
                <c:pt idx="6">
                  <c:v>99</c:v>
                </c:pt>
                <c:pt idx="7">
                  <c:v>99</c:v>
                </c:pt>
                <c:pt idx="8">
                  <c:v>98.5</c:v>
                </c:pt>
                <c:pt idx="9">
                  <c:v>98.5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7</c:v>
                </c:pt>
                <c:pt idx="15">
                  <c:v>95.5</c:v>
                </c:pt>
                <c:pt idx="16">
                  <c:v>95.5</c:v>
                </c:pt>
                <c:pt idx="17">
                  <c:v>94.5</c:v>
                </c:pt>
                <c:pt idx="18">
                  <c:v>91.5</c:v>
                </c:pt>
                <c:pt idx="19">
                  <c:v>90</c:v>
                </c:pt>
                <c:pt idx="20">
                  <c:v>86.5</c:v>
                </c:pt>
                <c:pt idx="21">
                  <c:v>85.5</c:v>
                </c:pt>
                <c:pt idx="22">
                  <c:v>81.5</c:v>
                </c:pt>
                <c:pt idx="23">
                  <c:v>73</c:v>
                </c:pt>
                <c:pt idx="24">
                  <c:v>66.5</c:v>
                </c:pt>
                <c:pt idx="25">
                  <c:v>63.5</c:v>
                </c:pt>
                <c:pt idx="26">
                  <c:v>51.5</c:v>
                </c:pt>
                <c:pt idx="27">
                  <c:v>45.499999999999993</c:v>
                </c:pt>
                <c:pt idx="28">
                  <c:v>41</c:v>
                </c:pt>
                <c:pt idx="29">
                  <c:v>26</c:v>
                </c:pt>
                <c:pt idx="30">
                  <c:v>20</c:v>
                </c:pt>
                <c:pt idx="31">
                  <c:v>15</c:v>
                </c:pt>
                <c:pt idx="32">
                  <c:v>7.5</c:v>
                </c:pt>
                <c:pt idx="33">
                  <c:v>1</c:v>
                </c:pt>
                <c:pt idx="3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D3A-423E-ACFB-18A4CFF3F425}"/>
            </c:ext>
          </c:extLst>
        </c:ser>
        <c:ser>
          <c:idx val="3"/>
          <c:order val="3"/>
          <c:tx>
            <c:strRef>
              <c:f>'Canton S M Threonin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Threonine'!$B$75:$AO$75</c:f>
              <c:numCache>
                <c:formatCode>General</c:formatCode>
                <c:ptCount val="40"/>
                <c:pt idx="0">
                  <c:v>100</c:v>
                </c:pt>
                <c:pt idx="1">
                  <c:v>99.004975124378106</c:v>
                </c:pt>
                <c:pt idx="2">
                  <c:v>99.004975124378106</c:v>
                </c:pt>
                <c:pt idx="3">
                  <c:v>98.507462686567166</c:v>
                </c:pt>
                <c:pt idx="4">
                  <c:v>98.009950248756212</c:v>
                </c:pt>
                <c:pt idx="5">
                  <c:v>98.009950248756212</c:v>
                </c:pt>
                <c:pt idx="6">
                  <c:v>98.009950248756212</c:v>
                </c:pt>
                <c:pt idx="7">
                  <c:v>98.009950248756212</c:v>
                </c:pt>
                <c:pt idx="8">
                  <c:v>97.014925373134332</c:v>
                </c:pt>
                <c:pt idx="9">
                  <c:v>97.014925373134332</c:v>
                </c:pt>
                <c:pt idx="10">
                  <c:v>96.517412935323378</c:v>
                </c:pt>
                <c:pt idx="11">
                  <c:v>95.522388059701498</c:v>
                </c:pt>
                <c:pt idx="12">
                  <c:v>94.527363184079604</c:v>
                </c:pt>
                <c:pt idx="13">
                  <c:v>94.029850746268664</c:v>
                </c:pt>
                <c:pt idx="14">
                  <c:v>93.53233830845771</c:v>
                </c:pt>
                <c:pt idx="15">
                  <c:v>93.53233830845771</c:v>
                </c:pt>
                <c:pt idx="16">
                  <c:v>91.044776119402982</c:v>
                </c:pt>
                <c:pt idx="17">
                  <c:v>91.044776119402982</c:v>
                </c:pt>
                <c:pt idx="18">
                  <c:v>90.049751243781088</c:v>
                </c:pt>
                <c:pt idx="19">
                  <c:v>90.049751243781088</c:v>
                </c:pt>
                <c:pt idx="20">
                  <c:v>89.054726368159209</c:v>
                </c:pt>
                <c:pt idx="21">
                  <c:v>88.557213930348254</c:v>
                </c:pt>
                <c:pt idx="22">
                  <c:v>87.06467661691542</c:v>
                </c:pt>
                <c:pt idx="23">
                  <c:v>81.592039800995025</c:v>
                </c:pt>
                <c:pt idx="24">
                  <c:v>80.597014925373131</c:v>
                </c:pt>
                <c:pt idx="25">
                  <c:v>78.109452736318403</c:v>
                </c:pt>
                <c:pt idx="26">
                  <c:v>71.144278606965173</c:v>
                </c:pt>
                <c:pt idx="27">
                  <c:v>65.174129353233837</c:v>
                </c:pt>
                <c:pt idx="28">
                  <c:v>63.184079601990049</c:v>
                </c:pt>
                <c:pt idx="29">
                  <c:v>55.223880597014926</c:v>
                </c:pt>
                <c:pt idx="30">
                  <c:v>47.761194029850749</c:v>
                </c:pt>
                <c:pt idx="31">
                  <c:v>39.800995024875618</c:v>
                </c:pt>
                <c:pt idx="32">
                  <c:v>28.855721393034827</c:v>
                </c:pt>
                <c:pt idx="33">
                  <c:v>21.890547263681597</c:v>
                </c:pt>
                <c:pt idx="34">
                  <c:v>17.910447761194021</c:v>
                </c:pt>
                <c:pt idx="35">
                  <c:v>13.930348258706474</c:v>
                </c:pt>
                <c:pt idx="36">
                  <c:v>6.4676616915422898</c:v>
                </c:pt>
                <c:pt idx="37">
                  <c:v>4.9751243781094558</c:v>
                </c:pt>
                <c:pt idx="38">
                  <c:v>2.4875621890547279</c:v>
                </c:pt>
                <c:pt idx="3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D3A-423E-ACFB-18A4CFF3F4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Canton S M Threonine'!$A$74</c15:sqref>
                        </c15:formulaRef>
                      </c:ext>
                    </c:extLst>
                    <c:strCache>
                      <c:ptCount val="1"/>
                      <c:pt idx="0">
                        <c:v>5 mM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Canton S M Threonine'!$B$71:$AO$71</c15:sqref>
                        </c15:formulaRef>
                      </c:ext>
                    </c:extLst>
                    <c:numCache>
                      <c:formatCode>0</c:formatCode>
                      <c:ptCount val="40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  <c:pt idx="30">
                        <c:v>65</c:v>
                      </c:pt>
                      <c:pt idx="31">
                        <c:v>67</c:v>
                      </c:pt>
                      <c:pt idx="32">
                        <c:v>69</c:v>
                      </c:pt>
                      <c:pt idx="33">
                        <c:v>71</c:v>
                      </c:pt>
                      <c:pt idx="34">
                        <c:v>73</c:v>
                      </c:pt>
                      <c:pt idx="35">
                        <c:v>75</c:v>
                      </c:pt>
                      <c:pt idx="36">
                        <c:v>77</c:v>
                      </c:pt>
                      <c:pt idx="37">
                        <c:v>79</c:v>
                      </c:pt>
                      <c:pt idx="38">
                        <c:v>81</c:v>
                      </c:pt>
                      <c:pt idx="39">
                        <c:v>83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Canton S M Threonine'!$B$74:$AN$74</c15:sqref>
                        </c15:formulaRef>
                      </c:ext>
                    </c:extLst>
                    <c:numCache>
                      <c:formatCode>General</c:formatCode>
                      <c:ptCount val="39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  <c:pt idx="30">
                        <c:v>100</c:v>
                      </c:pt>
                      <c:pt idx="31">
                        <c:v>100</c:v>
                      </c:pt>
                      <c:pt idx="32">
                        <c:v>100</c:v>
                      </c:pt>
                      <c:pt idx="33">
                        <c:v>100</c:v>
                      </c:pt>
                      <c:pt idx="34">
                        <c:v>100</c:v>
                      </c:pt>
                      <c:pt idx="35">
                        <c:v>100</c:v>
                      </c:pt>
                      <c:pt idx="36">
                        <c:v>100</c:v>
                      </c:pt>
                      <c:pt idx="37">
                        <c:v>100</c:v>
                      </c:pt>
                      <c:pt idx="38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DD3A-423E-ACFB-18A4CFF3F425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w1118 Males + Threon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M Threonin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w1118 M Threonine'!$B$72:$AO$72</c:f>
              <c:numCache>
                <c:formatCode>General</c:formatCode>
                <c:ptCount val="40"/>
                <c:pt idx="0">
                  <c:v>100</c:v>
                </c:pt>
                <c:pt idx="1">
                  <c:v>98.5</c:v>
                </c:pt>
                <c:pt idx="2">
                  <c:v>97</c:v>
                </c:pt>
                <c:pt idx="3">
                  <c:v>96</c:v>
                </c:pt>
                <c:pt idx="4">
                  <c:v>95.5</c:v>
                </c:pt>
                <c:pt idx="5">
                  <c:v>94</c:v>
                </c:pt>
                <c:pt idx="6">
                  <c:v>94</c:v>
                </c:pt>
                <c:pt idx="7">
                  <c:v>93.5</c:v>
                </c:pt>
                <c:pt idx="8">
                  <c:v>91.5</c:v>
                </c:pt>
                <c:pt idx="9">
                  <c:v>90.5</c:v>
                </c:pt>
                <c:pt idx="10">
                  <c:v>89</c:v>
                </c:pt>
                <c:pt idx="11">
                  <c:v>85</c:v>
                </c:pt>
                <c:pt idx="12">
                  <c:v>83</c:v>
                </c:pt>
                <c:pt idx="13">
                  <c:v>80</c:v>
                </c:pt>
                <c:pt idx="14">
                  <c:v>79</c:v>
                </c:pt>
                <c:pt idx="15">
                  <c:v>76</c:v>
                </c:pt>
                <c:pt idx="16">
                  <c:v>68.5</c:v>
                </c:pt>
                <c:pt idx="17">
                  <c:v>62</c:v>
                </c:pt>
                <c:pt idx="18">
                  <c:v>60</c:v>
                </c:pt>
                <c:pt idx="19">
                  <c:v>56.5</c:v>
                </c:pt>
                <c:pt idx="20">
                  <c:v>48.5</c:v>
                </c:pt>
                <c:pt idx="21">
                  <c:v>43.000000000000007</c:v>
                </c:pt>
                <c:pt idx="22">
                  <c:v>35</c:v>
                </c:pt>
                <c:pt idx="23">
                  <c:v>22</c:v>
                </c:pt>
                <c:pt idx="24">
                  <c:v>13</c:v>
                </c:pt>
                <c:pt idx="25">
                  <c:v>9</c:v>
                </c:pt>
                <c:pt idx="26">
                  <c:v>2.5</c:v>
                </c:pt>
                <c:pt idx="27">
                  <c:v>1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87B-4B5E-8798-391DF917B10D}"/>
            </c:ext>
          </c:extLst>
        </c:ser>
        <c:ser>
          <c:idx val="1"/>
          <c:order val="1"/>
          <c:tx>
            <c:strRef>
              <c:f>'w1118 M Threonin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w1118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w1118 M Threonine'!$B$73:$AJ$73</c:f>
              <c:numCache>
                <c:formatCode>General</c:formatCode>
                <c:ptCount val="35"/>
                <c:pt idx="0">
                  <c:v>100</c:v>
                </c:pt>
                <c:pt idx="1">
                  <c:v>99.5</c:v>
                </c:pt>
                <c:pt idx="2">
                  <c:v>99</c:v>
                </c:pt>
                <c:pt idx="3">
                  <c:v>98</c:v>
                </c:pt>
                <c:pt idx="4">
                  <c:v>97.5</c:v>
                </c:pt>
                <c:pt idx="5">
                  <c:v>97</c:v>
                </c:pt>
                <c:pt idx="6">
                  <c:v>97</c:v>
                </c:pt>
                <c:pt idx="7">
                  <c:v>97</c:v>
                </c:pt>
                <c:pt idx="8">
                  <c:v>96</c:v>
                </c:pt>
                <c:pt idx="9">
                  <c:v>96</c:v>
                </c:pt>
                <c:pt idx="10">
                  <c:v>96</c:v>
                </c:pt>
                <c:pt idx="11">
                  <c:v>95.5</c:v>
                </c:pt>
                <c:pt idx="12">
                  <c:v>95.5</c:v>
                </c:pt>
                <c:pt idx="13">
                  <c:v>94</c:v>
                </c:pt>
                <c:pt idx="14">
                  <c:v>91.5</c:v>
                </c:pt>
                <c:pt idx="15">
                  <c:v>90</c:v>
                </c:pt>
                <c:pt idx="16">
                  <c:v>89</c:v>
                </c:pt>
                <c:pt idx="17">
                  <c:v>87</c:v>
                </c:pt>
                <c:pt idx="18">
                  <c:v>85.5</c:v>
                </c:pt>
                <c:pt idx="19">
                  <c:v>81.5</c:v>
                </c:pt>
                <c:pt idx="20">
                  <c:v>73</c:v>
                </c:pt>
                <c:pt idx="21">
                  <c:v>70.5</c:v>
                </c:pt>
                <c:pt idx="22">
                  <c:v>65.5</c:v>
                </c:pt>
                <c:pt idx="23">
                  <c:v>56.5</c:v>
                </c:pt>
                <c:pt idx="24">
                  <c:v>46.5</c:v>
                </c:pt>
                <c:pt idx="25">
                  <c:v>40</c:v>
                </c:pt>
                <c:pt idx="26">
                  <c:v>24.5</c:v>
                </c:pt>
                <c:pt idx="27">
                  <c:v>15.5</c:v>
                </c:pt>
                <c:pt idx="28">
                  <c:v>12.5</c:v>
                </c:pt>
                <c:pt idx="29">
                  <c:v>7.5</c:v>
                </c:pt>
                <c:pt idx="30">
                  <c:v>5.5</c:v>
                </c:pt>
                <c:pt idx="31">
                  <c:v>4.5</c:v>
                </c:pt>
                <c:pt idx="32">
                  <c:v>2.5</c:v>
                </c:pt>
                <c:pt idx="33">
                  <c:v>1</c:v>
                </c:pt>
                <c:pt idx="3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87B-4B5E-8798-391DF917B10D}"/>
            </c:ext>
          </c:extLst>
        </c:ser>
        <c:ser>
          <c:idx val="3"/>
          <c:order val="3"/>
          <c:tx>
            <c:strRef>
              <c:f>'w1118 M Threonin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M Threon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w1118 M Threonine'!$B$75:$AO$75</c:f>
              <c:numCache>
                <c:formatCode>General</c:formatCode>
                <c:ptCount val="40"/>
                <c:pt idx="0">
                  <c:v>100</c:v>
                </c:pt>
                <c:pt idx="1">
                  <c:v>99.5</c:v>
                </c:pt>
                <c:pt idx="2">
                  <c:v>99</c:v>
                </c:pt>
                <c:pt idx="3">
                  <c:v>97</c:v>
                </c:pt>
                <c:pt idx="4">
                  <c:v>96.5</c:v>
                </c:pt>
                <c:pt idx="5">
                  <c:v>92.5</c:v>
                </c:pt>
                <c:pt idx="6">
                  <c:v>86</c:v>
                </c:pt>
                <c:pt idx="7">
                  <c:v>77.5</c:v>
                </c:pt>
                <c:pt idx="8">
                  <c:v>73</c:v>
                </c:pt>
                <c:pt idx="9">
                  <c:v>70</c:v>
                </c:pt>
                <c:pt idx="10">
                  <c:v>69.5</c:v>
                </c:pt>
                <c:pt idx="11">
                  <c:v>68</c:v>
                </c:pt>
                <c:pt idx="12">
                  <c:v>67.5</c:v>
                </c:pt>
                <c:pt idx="13">
                  <c:v>66</c:v>
                </c:pt>
                <c:pt idx="14">
                  <c:v>65</c:v>
                </c:pt>
                <c:pt idx="15">
                  <c:v>63</c:v>
                </c:pt>
                <c:pt idx="16">
                  <c:v>60.5</c:v>
                </c:pt>
                <c:pt idx="17">
                  <c:v>59</c:v>
                </c:pt>
                <c:pt idx="18">
                  <c:v>56.5</c:v>
                </c:pt>
                <c:pt idx="19">
                  <c:v>56</c:v>
                </c:pt>
                <c:pt idx="20">
                  <c:v>55</c:v>
                </c:pt>
                <c:pt idx="21">
                  <c:v>54</c:v>
                </c:pt>
                <c:pt idx="22">
                  <c:v>52.5</c:v>
                </c:pt>
                <c:pt idx="23">
                  <c:v>50</c:v>
                </c:pt>
                <c:pt idx="24">
                  <c:v>48</c:v>
                </c:pt>
                <c:pt idx="25">
                  <c:v>44.999999999999993</c:v>
                </c:pt>
                <c:pt idx="26">
                  <c:v>40.5</c:v>
                </c:pt>
                <c:pt idx="27">
                  <c:v>35.5</c:v>
                </c:pt>
                <c:pt idx="28">
                  <c:v>33</c:v>
                </c:pt>
                <c:pt idx="29">
                  <c:v>23.5</c:v>
                </c:pt>
                <c:pt idx="30">
                  <c:v>18</c:v>
                </c:pt>
                <c:pt idx="31">
                  <c:v>16</c:v>
                </c:pt>
                <c:pt idx="32">
                  <c:v>6.5</c:v>
                </c:pt>
                <c:pt idx="33">
                  <c:v>3.5</c:v>
                </c:pt>
                <c:pt idx="34">
                  <c:v>2.5</c:v>
                </c:pt>
                <c:pt idx="35">
                  <c:v>2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87B-4B5E-8798-391DF917B1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w1118 M Threonine'!$A$74</c15:sqref>
                        </c15:formulaRef>
                      </c:ext>
                    </c:extLst>
                    <c:strCache>
                      <c:ptCount val="1"/>
                      <c:pt idx="0">
                        <c:v>5 mM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w1118 M Threonine'!$B$71:$AO$71</c15:sqref>
                        </c15:formulaRef>
                      </c:ext>
                    </c:extLst>
                    <c:numCache>
                      <c:formatCode>0</c:formatCode>
                      <c:ptCount val="40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  <c:pt idx="30">
                        <c:v>65</c:v>
                      </c:pt>
                      <c:pt idx="31">
                        <c:v>67</c:v>
                      </c:pt>
                      <c:pt idx="32">
                        <c:v>69</c:v>
                      </c:pt>
                      <c:pt idx="33">
                        <c:v>71</c:v>
                      </c:pt>
                      <c:pt idx="34">
                        <c:v>73</c:v>
                      </c:pt>
                      <c:pt idx="35">
                        <c:v>75</c:v>
                      </c:pt>
                      <c:pt idx="36">
                        <c:v>77</c:v>
                      </c:pt>
                      <c:pt idx="37">
                        <c:v>79</c:v>
                      </c:pt>
                      <c:pt idx="38">
                        <c:v>81</c:v>
                      </c:pt>
                      <c:pt idx="39">
                        <c:v>83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w1118 M Threonine'!$B$74:$AO$74</c15:sqref>
                        </c15:formulaRef>
                      </c:ext>
                    </c:extLst>
                    <c:numCache>
                      <c:formatCode>General</c:formatCode>
                      <c:ptCount val="40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  <c:pt idx="30">
                        <c:v>100</c:v>
                      </c:pt>
                      <c:pt idx="31">
                        <c:v>100</c:v>
                      </c:pt>
                      <c:pt idx="32">
                        <c:v>100</c:v>
                      </c:pt>
                      <c:pt idx="33">
                        <c:v>100</c:v>
                      </c:pt>
                      <c:pt idx="34">
                        <c:v>100</c:v>
                      </c:pt>
                      <c:pt idx="35">
                        <c:v>100</c:v>
                      </c:pt>
                      <c:pt idx="36">
                        <c:v>100</c:v>
                      </c:pt>
                      <c:pt idx="37">
                        <c:v>100</c:v>
                      </c:pt>
                      <c:pt idx="38">
                        <c:v>100</c:v>
                      </c:pt>
                      <c:pt idx="39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887B-4B5E-8798-391DF917B10D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anton S Males + Chol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M Cholin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anton S M Chol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Choline'!$B$72:$AF$72</c:f>
              <c:numCache>
                <c:formatCode>General</c:formatCode>
                <c:ptCount val="31"/>
                <c:pt idx="0">
                  <c:v>100</c:v>
                </c:pt>
                <c:pt idx="1">
                  <c:v>98.5</c:v>
                </c:pt>
                <c:pt idx="2">
                  <c:v>97.5</c:v>
                </c:pt>
                <c:pt idx="3">
                  <c:v>97</c:v>
                </c:pt>
                <c:pt idx="4">
                  <c:v>97</c:v>
                </c:pt>
                <c:pt idx="5">
                  <c:v>94.5</c:v>
                </c:pt>
                <c:pt idx="6">
                  <c:v>93</c:v>
                </c:pt>
                <c:pt idx="7">
                  <c:v>93</c:v>
                </c:pt>
                <c:pt idx="8">
                  <c:v>93</c:v>
                </c:pt>
                <c:pt idx="9">
                  <c:v>92.5</c:v>
                </c:pt>
                <c:pt idx="10">
                  <c:v>91.5</c:v>
                </c:pt>
                <c:pt idx="11">
                  <c:v>90</c:v>
                </c:pt>
                <c:pt idx="12">
                  <c:v>88</c:v>
                </c:pt>
                <c:pt idx="13">
                  <c:v>86</c:v>
                </c:pt>
                <c:pt idx="14">
                  <c:v>83</c:v>
                </c:pt>
                <c:pt idx="15">
                  <c:v>80</c:v>
                </c:pt>
                <c:pt idx="16">
                  <c:v>79.5</c:v>
                </c:pt>
                <c:pt idx="17">
                  <c:v>69</c:v>
                </c:pt>
                <c:pt idx="18">
                  <c:v>62.5</c:v>
                </c:pt>
                <c:pt idx="19">
                  <c:v>56.5</c:v>
                </c:pt>
                <c:pt idx="20">
                  <c:v>51.5</c:v>
                </c:pt>
                <c:pt idx="21">
                  <c:v>45.499999999999993</c:v>
                </c:pt>
                <c:pt idx="22">
                  <c:v>40</c:v>
                </c:pt>
                <c:pt idx="23">
                  <c:v>32.5</c:v>
                </c:pt>
                <c:pt idx="24">
                  <c:v>24.5</c:v>
                </c:pt>
                <c:pt idx="25">
                  <c:v>20</c:v>
                </c:pt>
                <c:pt idx="26">
                  <c:v>16</c:v>
                </c:pt>
                <c:pt idx="27">
                  <c:v>11.5</c:v>
                </c:pt>
                <c:pt idx="28">
                  <c:v>6</c:v>
                </c:pt>
                <c:pt idx="29">
                  <c:v>1</c:v>
                </c:pt>
                <c:pt idx="3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4B2-4D67-AF5D-E97FBFEC04DE}"/>
            </c:ext>
          </c:extLst>
        </c:ser>
        <c:ser>
          <c:idx val="1"/>
          <c:order val="1"/>
          <c:tx>
            <c:strRef>
              <c:f>'Canton S M Cholin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Canton S M Chol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Choline'!$B$73:$AJ$73</c:f>
              <c:numCache>
                <c:formatCode>General</c:formatCode>
                <c:ptCount val="35"/>
                <c:pt idx="0">
                  <c:v>100</c:v>
                </c:pt>
                <c:pt idx="1">
                  <c:v>99</c:v>
                </c:pt>
                <c:pt idx="2">
                  <c:v>99</c:v>
                </c:pt>
                <c:pt idx="3">
                  <c:v>99</c:v>
                </c:pt>
                <c:pt idx="4">
                  <c:v>99</c:v>
                </c:pt>
                <c:pt idx="5">
                  <c:v>99</c:v>
                </c:pt>
                <c:pt idx="6">
                  <c:v>99</c:v>
                </c:pt>
                <c:pt idx="7">
                  <c:v>99</c:v>
                </c:pt>
                <c:pt idx="8">
                  <c:v>98.5</c:v>
                </c:pt>
                <c:pt idx="9">
                  <c:v>98.5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7</c:v>
                </c:pt>
                <c:pt idx="15">
                  <c:v>95.5</c:v>
                </c:pt>
                <c:pt idx="16">
                  <c:v>95.5</c:v>
                </c:pt>
                <c:pt idx="17">
                  <c:v>94.5</c:v>
                </c:pt>
                <c:pt idx="18">
                  <c:v>91.5</c:v>
                </c:pt>
                <c:pt idx="19">
                  <c:v>90</c:v>
                </c:pt>
                <c:pt idx="20">
                  <c:v>86.5</c:v>
                </c:pt>
                <c:pt idx="21">
                  <c:v>85.5</c:v>
                </c:pt>
                <c:pt idx="22">
                  <c:v>81.5</c:v>
                </c:pt>
                <c:pt idx="23">
                  <c:v>73</c:v>
                </c:pt>
                <c:pt idx="24">
                  <c:v>66.5</c:v>
                </c:pt>
                <c:pt idx="25">
                  <c:v>63.5</c:v>
                </c:pt>
                <c:pt idx="26">
                  <c:v>51.5</c:v>
                </c:pt>
                <c:pt idx="27">
                  <c:v>45.499999999999993</c:v>
                </c:pt>
                <c:pt idx="28">
                  <c:v>41</c:v>
                </c:pt>
                <c:pt idx="29">
                  <c:v>26</c:v>
                </c:pt>
                <c:pt idx="30">
                  <c:v>20</c:v>
                </c:pt>
                <c:pt idx="31">
                  <c:v>15</c:v>
                </c:pt>
                <c:pt idx="32">
                  <c:v>7.5</c:v>
                </c:pt>
                <c:pt idx="33">
                  <c:v>1</c:v>
                </c:pt>
                <c:pt idx="3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4B2-4D67-AF5D-E97FBFEC04DE}"/>
            </c:ext>
          </c:extLst>
        </c:ser>
        <c:ser>
          <c:idx val="3"/>
          <c:order val="3"/>
          <c:tx>
            <c:strRef>
              <c:f>'Canton S M Cholin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M Choline'!$B$71:$AO$71</c:f>
              <c:numCache>
                <c:formatCode>0</c:formatCode>
                <c:ptCount val="4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  <c:pt idx="37">
                  <c:v>79</c:v>
                </c:pt>
                <c:pt idx="38">
                  <c:v>81</c:v>
                </c:pt>
                <c:pt idx="39">
                  <c:v>83</c:v>
                </c:pt>
              </c:numCache>
            </c:numRef>
          </c:cat>
          <c:val>
            <c:numRef>
              <c:f>'Canton S M Choline'!$B$75:$AO$75</c:f>
              <c:numCache>
                <c:formatCode>General</c:formatCode>
                <c:ptCount val="40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.5</c:v>
                </c:pt>
                <c:pt idx="4">
                  <c:v>99.5</c:v>
                </c:pt>
                <c:pt idx="5">
                  <c:v>99</c:v>
                </c:pt>
                <c:pt idx="6">
                  <c:v>99</c:v>
                </c:pt>
                <c:pt idx="7">
                  <c:v>99</c:v>
                </c:pt>
                <c:pt idx="8">
                  <c:v>98.5</c:v>
                </c:pt>
                <c:pt idx="9">
                  <c:v>98.5</c:v>
                </c:pt>
                <c:pt idx="10">
                  <c:v>98</c:v>
                </c:pt>
                <c:pt idx="11">
                  <c:v>97</c:v>
                </c:pt>
                <c:pt idx="12">
                  <c:v>97</c:v>
                </c:pt>
                <c:pt idx="13">
                  <c:v>96.5</c:v>
                </c:pt>
                <c:pt idx="14">
                  <c:v>96.5</c:v>
                </c:pt>
                <c:pt idx="15">
                  <c:v>95.5</c:v>
                </c:pt>
                <c:pt idx="16">
                  <c:v>94.5</c:v>
                </c:pt>
                <c:pt idx="17">
                  <c:v>93</c:v>
                </c:pt>
                <c:pt idx="18">
                  <c:v>93</c:v>
                </c:pt>
                <c:pt idx="19">
                  <c:v>92</c:v>
                </c:pt>
                <c:pt idx="20">
                  <c:v>88.5</c:v>
                </c:pt>
                <c:pt idx="21">
                  <c:v>86.5</c:v>
                </c:pt>
                <c:pt idx="22">
                  <c:v>83</c:v>
                </c:pt>
                <c:pt idx="23">
                  <c:v>78</c:v>
                </c:pt>
                <c:pt idx="24">
                  <c:v>76</c:v>
                </c:pt>
                <c:pt idx="25">
                  <c:v>74</c:v>
                </c:pt>
                <c:pt idx="26">
                  <c:v>69</c:v>
                </c:pt>
                <c:pt idx="27">
                  <c:v>64.5</c:v>
                </c:pt>
                <c:pt idx="28">
                  <c:v>59</c:v>
                </c:pt>
                <c:pt idx="29">
                  <c:v>45.499999999999993</c:v>
                </c:pt>
                <c:pt idx="30">
                  <c:v>38</c:v>
                </c:pt>
                <c:pt idx="31">
                  <c:v>31</c:v>
                </c:pt>
                <c:pt idx="32">
                  <c:v>19</c:v>
                </c:pt>
                <c:pt idx="33">
                  <c:v>14.5</c:v>
                </c:pt>
                <c:pt idx="34">
                  <c:v>12</c:v>
                </c:pt>
                <c:pt idx="35">
                  <c:v>9</c:v>
                </c:pt>
                <c:pt idx="36">
                  <c:v>5.5</c:v>
                </c:pt>
                <c:pt idx="37">
                  <c:v>2</c:v>
                </c:pt>
                <c:pt idx="38">
                  <c:v>0.5</c:v>
                </c:pt>
                <c:pt idx="3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4B2-4D67-AF5D-E97FBFEC04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Canton S M Choline'!$A$74</c15:sqref>
                        </c15:formulaRef>
                      </c:ext>
                    </c:extLst>
                    <c:strCache>
                      <c:ptCount val="1"/>
                      <c:pt idx="0">
                        <c:v>5 mM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Canton S M Choline'!$B$71:$AO$71</c15:sqref>
                        </c15:formulaRef>
                      </c:ext>
                    </c:extLst>
                    <c:numCache>
                      <c:formatCode>0</c:formatCode>
                      <c:ptCount val="40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  <c:pt idx="30">
                        <c:v>65</c:v>
                      </c:pt>
                      <c:pt idx="31">
                        <c:v>67</c:v>
                      </c:pt>
                      <c:pt idx="32">
                        <c:v>69</c:v>
                      </c:pt>
                      <c:pt idx="33">
                        <c:v>71</c:v>
                      </c:pt>
                      <c:pt idx="34">
                        <c:v>73</c:v>
                      </c:pt>
                      <c:pt idx="35">
                        <c:v>75</c:v>
                      </c:pt>
                      <c:pt idx="36">
                        <c:v>77</c:v>
                      </c:pt>
                      <c:pt idx="37">
                        <c:v>79</c:v>
                      </c:pt>
                      <c:pt idx="38">
                        <c:v>81</c:v>
                      </c:pt>
                      <c:pt idx="39">
                        <c:v>83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Canton S M Choline'!$B$74:$AO$74</c15:sqref>
                        </c15:formulaRef>
                      </c:ext>
                    </c:extLst>
                    <c:numCache>
                      <c:formatCode>General</c:formatCode>
                      <c:ptCount val="40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  <c:pt idx="30">
                        <c:v>100</c:v>
                      </c:pt>
                      <c:pt idx="31">
                        <c:v>100</c:v>
                      </c:pt>
                      <c:pt idx="32">
                        <c:v>100</c:v>
                      </c:pt>
                      <c:pt idx="33">
                        <c:v>100</c:v>
                      </c:pt>
                      <c:pt idx="34">
                        <c:v>100</c:v>
                      </c:pt>
                      <c:pt idx="35">
                        <c:v>100</c:v>
                      </c:pt>
                      <c:pt idx="36">
                        <c:v>100</c:v>
                      </c:pt>
                      <c:pt idx="37">
                        <c:v>100</c:v>
                      </c:pt>
                      <c:pt idx="38">
                        <c:v>100</c:v>
                      </c:pt>
                      <c:pt idx="39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54B2-4D67-AF5D-E97FBFEC04DE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anton S Females + Histid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F Histidin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Canton S F Histidine'!$B$71:$AL$71</c:f>
              <c:numCache>
                <c:formatCode>0</c:formatCode>
                <c:ptCount val="3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</c:numCache>
            </c:numRef>
          </c:cat>
          <c:val>
            <c:numRef>
              <c:f>'Canton S F Histidine'!$B$72:$AL$72</c:f>
              <c:numCache>
                <c:formatCode>General</c:formatCode>
                <c:ptCount val="37"/>
                <c:pt idx="0">
                  <c:v>100</c:v>
                </c:pt>
                <c:pt idx="1">
                  <c:v>99.5</c:v>
                </c:pt>
                <c:pt idx="2">
                  <c:v>94</c:v>
                </c:pt>
                <c:pt idx="3">
                  <c:v>80</c:v>
                </c:pt>
                <c:pt idx="4">
                  <c:v>77</c:v>
                </c:pt>
                <c:pt idx="5">
                  <c:v>71.5</c:v>
                </c:pt>
                <c:pt idx="6">
                  <c:v>69.5</c:v>
                </c:pt>
                <c:pt idx="7">
                  <c:v>69.5</c:v>
                </c:pt>
                <c:pt idx="8">
                  <c:v>69</c:v>
                </c:pt>
                <c:pt idx="9">
                  <c:v>69</c:v>
                </c:pt>
                <c:pt idx="10">
                  <c:v>69</c:v>
                </c:pt>
                <c:pt idx="11">
                  <c:v>68.5</c:v>
                </c:pt>
                <c:pt idx="12">
                  <c:v>67.5</c:v>
                </c:pt>
                <c:pt idx="13">
                  <c:v>66.5</c:v>
                </c:pt>
                <c:pt idx="14">
                  <c:v>64.5</c:v>
                </c:pt>
                <c:pt idx="15">
                  <c:v>60</c:v>
                </c:pt>
                <c:pt idx="16">
                  <c:v>54</c:v>
                </c:pt>
                <c:pt idx="17">
                  <c:v>38.5</c:v>
                </c:pt>
                <c:pt idx="18">
                  <c:v>31</c:v>
                </c:pt>
                <c:pt idx="19">
                  <c:v>28</c:v>
                </c:pt>
                <c:pt idx="20">
                  <c:v>21.5</c:v>
                </c:pt>
                <c:pt idx="21">
                  <c:v>18.5</c:v>
                </c:pt>
                <c:pt idx="22">
                  <c:v>16</c:v>
                </c:pt>
                <c:pt idx="23">
                  <c:v>7</c:v>
                </c:pt>
                <c:pt idx="24">
                  <c:v>5.5</c:v>
                </c:pt>
                <c:pt idx="25">
                  <c:v>3</c:v>
                </c:pt>
                <c:pt idx="26">
                  <c:v>1</c:v>
                </c:pt>
                <c:pt idx="27">
                  <c:v>0.5</c:v>
                </c:pt>
                <c:pt idx="28">
                  <c:v>0.5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EE2-47E4-B070-FFF44858052A}"/>
            </c:ext>
          </c:extLst>
        </c:ser>
        <c:ser>
          <c:idx val="1"/>
          <c:order val="1"/>
          <c:tx>
            <c:strRef>
              <c:f>'Canton S F Histidin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Canton S F Histidine'!$B$71:$AL$71</c:f>
              <c:numCache>
                <c:formatCode>0</c:formatCode>
                <c:ptCount val="3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</c:numCache>
            </c:numRef>
          </c:cat>
          <c:val>
            <c:numRef>
              <c:f>'Canton S F Histidine'!$B$73:$AL$73</c:f>
              <c:numCache>
                <c:formatCode>General</c:formatCode>
                <c:ptCount val="37"/>
                <c:pt idx="0">
                  <c:v>100</c:v>
                </c:pt>
                <c:pt idx="1">
                  <c:v>98.5</c:v>
                </c:pt>
                <c:pt idx="2">
                  <c:v>98.5</c:v>
                </c:pt>
                <c:pt idx="3">
                  <c:v>98.5</c:v>
                </c:pt>
                <c:pt idx="4">
                  <c:v>98.5</c:v>
                </c:pt>
                <c:pt idx="5">
                  <c:v>98.5</c:v>
                </c:pt>
                <c:pt idx="6">
                  <c:v>98.5</c:v>
                </c:pt>
                <c:pt idx="7">
                  <c:v>98</c:v>
                </c:pt>
                <c:pt idx="8">
                  <c:v>98</c:v>
                </c:pt>
                <c:pt idx="9">
                  <c:v>98</c:v>
                </c:pt>
                <c:pt idx="10">
                  <c:v>97.5</c:v>
                </c:pt>
                <c:pt idx="11">
                  <c:v>97</c:v>
                </c:pt>
                <c:pt idx="12">
                  <c:v>95.5</c:v>
                </c:pt>
                <c:pt idx="13">
                  <c:v>95</c:v>
                </c:pt>
                <c:pt idx="14">
                  <c:v>94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0.5</c:v>
                </c:pt>
                <c:pt idx="19">
                  <c:v>89.5</c:v>
                </c:pt>
                <c:pt idx="20">
                  <c:v>88.5</c:v>
                </c:pt>
                <c:pt idx="21">
                  <c:v>85.5</c:v>
                </c:pt>
                <c:pt idx="22">
                  <c:v>82</c:v>
                </c:pt>
                <c:pt idx="23">
                  <c:v>78.5</c:v>
                </c:pt>
                <c:pt idx="24">
                  <c:v>77.5</c:v>
                </c:pt>
                <c:pt idx="25">
                  <c:v>75</c:v>
                </c:pt>
                <c:pt idx="26">
                  <c:v>74</c:v>
                </c:pt>
                <c:pt idx="27">
                  <c:v>70</c:v>
                </c:pt>
                <c:pt idx="28">
                  <c:v>67</c:v>
                </c:pt>
                <c:pt idx="29">
                  <c:v>56</c:v>
                </c:pt>
                <c:pt idx="30">
                  <c:v>48.5</c:v>
                </c:pt>
                <c:pt idx="31">
                  <c:v>46</c:v>
                </c:pt>
                <c:pt idx="32">
                  <c:v>33</c:v>
                </c:pt>
                <c:pt idx="33">
                  <c:v>20.5</c:v>
                </c:pt>
                <c:pt idx="34">
                  <c:v>10.5</c:v>
                </c:pt>
                <c:pt idx="35">
                  <c:v>1</c:v>
                </c:pt>
                <c:pt idx="3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EE2-47E4-B070-FFF44858052A}"/>
            </c:ext>
          </c:extLst>
        </c:ser>
        <c:ser>
          <c:idx val="3"/>
          <c:order val="3"/>
          <c:tx>
            <c:strRef>
              <c:f>'Canton S F Histidin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F Histidine'!$B$71:$AL$71</c:f>
              <c:numCache>
                <c:formatCode>0</c:formatCode>
                <c:ptCount val="3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  <c:pt idx="35">
                  <c:v>75</c:v>
                </c:pt>
                <c:pt idx="36">
                  <c:v>77</c:v>
                </c:pt>
              </c:numCache>
            </c:numRef>
          </c:cat>
          <c:val>
            <c:numRef>
              <c:f>'Canton S F Histidine'!$B$75:$AH$75</c:f>
              <c:numCache>
                <c:formatCode>General</c:formatCode>
                <c:ptCount val="3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99.5</c:v>
                </c:pt>
                <c:pt idx="8">
                  <c:v>99.5</c:v>
                </c:pt>
                <c:pt idx="9">
                  <c:v>98.5</c:v>
                </c:pt>
                <c:pt idx="10">
                  <c:v>98.5</c:v>
                </c:pt>
                <c:pt idx="11">
                  <c:v>95</c:v>
                </c:pt>
                <c:pt idx="12">
                  <c:v>92</c:v>
                </c:pt>
                <c:pt idx="13">
                  <c:v>87.5</c:v>
                </c:pt>
                <c:pt idx="14">
                  <c:v>86.5</c:v>
                </c:pt>
                <c:pt idx="15">
                  <c:v>82</c:v>
                </c:pt>
                <c:pt idx="16">
                  <c:v>80</c:v>
                </c:pt>
                <c:pt idx="17">
                  <c:v>78.5</c:v>
                </c:pt>
                <c:pt idx="18">
                  <c:v>75</c:v>
                </c:pt>
                <c:pt idx="19">
                  <c:v>73</c:v>
                </c:pt>
                <c:pt idx="20">
                  <c:v>67.5</c:v>
                </c:pt>
                <c:pt idx="21">
                  <c:v>64.5</c:v>
                </c:pt>
                <c:pt idx="22">
                  <c:v>58.5</c:v>
                </c:pt>
                <c:pt idx="23">
                  <c:v>53</c:v>
                </c:pt>
                <c:pt idx="24">
                  <c:v>45.499999999999993</c:v>
                </c:pt>
                <c:pt idx="25">
                  <c:v>36.5</c:v>
                </c:pt>
                <c:pt idx="26">
                  <c:v>24.5</c:v>
                </c:pt>
                <c:pt idx="27">
                  <c:v>17</c:v>
                </c:pt>
                <c:pt idx="28">
                  <c:v>14.5</c:v>
                </c:pt>
                <c:pt idx="29">
                  <c:v>7.5</c:v>
                </c:pt>
                <c:pt idx="30">
                  <c:v>5.5</c:v>
                </c:pt>
                <c:pt idx="31">
                  <c:v>4</c:v>
                </c:pt>
                <c:pt idx="32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EE2-47E4-B070-FFF448580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Canton S F Histidine'!$A$74</c15:sqref>
                        </c15:formulaRef>
                      </c:ext>
                    </c:extLst>
                    <c:strCache>
                      <c:ptCount val="1"/>
                      <c:pt idx="0">
                        <c:v>5 mM</c:v>
                      </c:pt>
                    </c:strCache>
                  </c:strRef>
                </c:tx>
                <c:spPr>
                  <a:ln w="28575" cap="rnd">
                    <a:solidFill>
                      <a:srgbClr val="FF0000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Canton S F Histidine'!$B$71:$AL$71</c15:sqref>
                        </c15:formulaRef>
                      </c:ext>
                    </c:extLst>
                    <c:numCache>
                      <c:formatCode>0</c:formatCode>
                      <c:ptCount val="37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  <c:pt idx="30">
                        <c:v>65</c:v>
                      </c:pt>
                      <c:pt idx="31">
                        <c:v>67</c:v>
                      </c:pt>
                      <c:pt idx="32">
                        <c:v>69</c:v>
                      </c:pt>
                      <c:pt idx="33">
                        <c:v>71</c:v>
                      </c:pt>
                      <c:pt idx="34">
                        <c:v>73</c:v>
                      </c:pt>
                      <c:pt idx="35">
                        <c:v>75</c:v>
                      </c:pt>
                      <c:pt idx="36">
                        <c:v>77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Canton S F Histidine'!$B$74:$AL$74</c15:sqref>
                        </c15:formulaRef>
                      </c:ext>
                    </c:extLst>
                    <c:numCache>
                      <c:formatCode>General</c:formatCode>
                      <c:ptCount val="37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  <c:pt idx="30">
                        <c:v>100</c:v>
                      </c:pt>
                      <c:pt idx="31">
                        <c:v>100</c:v>
                      </c:pt>
                      <c:pt idx="32">
                        <c:v>100</c:v>
                      </c:pt>
                      <c:pt idx="33">
                        <c:v>100</c:v>
                      </c:pt>
                      <c:pt idx="34">
                        <c:v>100</c:v>
                      </c:pt>
                      <c:pt idx="35">
                        <c:v>100</c:v>
                      </c:pt>
                      <c:pt idx="36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CEE2-47E4-B070-FFF44858052A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tickMarkSkip val="10"/>
        <c:noMultiLvlLbl val="0"/>
      </c:catAx>
      <c:valAx>
        <c:axId val="2027334399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w1118 Females + Chol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Female + Chol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Female + Chol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Choline'!$B$72:$AA$72</c:f>
              <c:numCache>
                <c:formatCode>General</c:formatCode>
                <c:ptCount val="26"/>
                <c:pt idx="0">
                  <c:v>100</c:v>
                </c:pt>
                <c:pt idx="1">
                  <c:v>98.369565217391298</c:v>
                </c:pt>
                <c:pt idx="2">
                  <c:v>94.565217391304344</c:v>
                </c:pt>
                <c:pt idx="3">
                  <c:v>92.934782608695656</c:v>
                </c:pt>
                <c:pt idx="4">
                  <c:v>92.934782608695656</c:v>
                </c:pt>
                <c:pt idx="5">
                  <c:v>91.304347826086953</c:v>
                </c:pt>
                <c:pt idx="6">
                  <c:v>91.304347826086953</c:v>
                </c:pt>
                <c:pt idx="7">
                  <c:v>89.673913043478265</c:v>
                </c:pt>
                <c:pt idx="8">
                  <c:v>88.043478260869563</c:v>
                </c:pt>
                <c:pt idx="9">
                  <c:v>86.956521739130437</c:v>
                </c:pt>
                <c:pt idx="10">
                  <c:v>82.608695652173907</c:v>
                </c:pt>
                <c:pt idx="11">
                  <c:v>77.173913043478265</c:v>
                </c:pt>
                <c:pt idx="12">
                  <c:v>72.282608695652172</c:v>
                </c:pt>
                <c:pt idx="13">
                  <c:v>66.304347826086953</c:v>
                </c:pt>
                <c:pt idx="14">
                  <c:v>57.608695652173914</c:v>
                </c:pt>
                <c:pt idx="15">
                  <c:v>53.260869565217391</c:v>
                </c:pt>
                <c:pt idx="16">
                  <c:v>46.739130434782602</c:v>
                </c:pt>
                <c:pt idx="17">
                  <c:v>36.413043478260867</c:v>
                </c:pt>
                <c:pt idx="18">
                  <c:v>29.347826086956516</c:v>
                </c:pt>
                <c:pt idx="19">
                  <c:v>24.456521739130437</c:v>
                </c:pt>
                <c:pt idx="20">
                  <c:v>16.304347826086953</c:v>
                </c:pt>
                <c:pt idx="21">
                  <c:v>9.2391304347826093</c:v>
                </c:pt>
                <c:pt idx="22">
                  <c:v>9.2391304347826093</c:v>
                </c:pt>
                <c:pt idx="23">
                  <c:v>5.9782608695652186</c:v>
                </c:pt>
                <c:pt idx="24">
                  <c:v>3.8043478260869534</c:v>
                </c:pt>
                <c:pt idx="25">
                  <c:v>1.63043478260868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4AE-4AFF-937F-9CC790D72732}"/>
            </c:ext>
          </c:extLst>
        </c:ser>
        <c:ser>
          <c:idx val="1"/>
          <c:order val="1"/>
          <c:tx>
            <c:strRef>
              <c:f>'w1118 Female + Chol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Female + Chol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Choline'!$B$73:$AA$73</c:f>
              <c:numCache>
                <c:formatCode>General</c:formatCode>
                <c:ptCount val="26"/>
                <c:pt idx="0">
                  <c:v>100</c:v>
                </c:pt>
                <c:pt idx="1">
                  <c:v>100</c:v>
                </c:pt>
                <c:pt idx="2">
                  <c:v>97.512437810945272</c:v>
                </c:pt>
                <c:pt idx="3">
                  <c:v>96.019900497512438</c:v>
                </c:pt>
                <c:pt idx="4">
                  <c:v>93.53233830845771</c:v>
                </c:pt>
                <c:pt idx="5">
                  <c:v>91.044776119402982</c:v>
                </c:pt>
                <c:pt idx="6">
                  <c:v>90.049751243781088</c:v>
                </c:pt>
                <c:pt idx="7">
                  <c:v>88.059701492537314</c:v>
                </c:pt>
                <c:pt idx="8">
                  <c:v>85.572139303482587</c:v>
                </c:pt>
                <c:pt idx="9">
                  <c:v>83.582089552238813</c:v>
                </c:pt>
                <c:pt idx="10">
                  <c:v>80.099502487562191</c:v>
                </c:pt>
                <c:pt idx="11">
                  <c:v>77.114427860696509</c:v>
                </c:pt>
                <c:pt idx="12">
                  <c:v>73.134328358208961</c:v>
                </c:pt>
                <c:pt idx="13">
                  <c:v>68.159203980099505</c:v>
                </c:pt>
                <c:pt idx="14">
                  <c:v>59.203980099502488</c:v>
                </c:pt>
                <c:pt idx="15">
                  <c:v>53.731343283582092</c:v>
                </c:pt>
                <c:pt idx="16">
                  <c:v>50.24875621890547</c:v>
                </c:pt>
                <c:pt idx="17">
                  <c:v>28.855721393034827</c:v>
                </c:pt>
                <c:pt idx="18">
                  <c:v>25.373134328358205</c:v>
                </c:pt>
                <c:pt idx="19">
                  <c:v>18.407960199004975</c:v>
                </c:pt>
                <c:pt idx="20">
                  <c:v>10.945273631840791</c:v>
                </c:pt>
                <c:pt idx="21">
                  <c:v>6.9651741293532297</c:v>
                </c:pt>
                <c:pt idx="22">
                  <c:v>3.4825870646766077</c:v>
                </c:pt>
                <c:pt idx="23">
                  <c:v>0.4975124378109399</c:v>
                </c:pt>
                <c:pt idx="24">
                  <c:v>0.4975124378109399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4AE-4AFF-937F-9CC790D72732}"/>
            </c:ext>
          </c:extLst>
        </c:ser>
        <c:ser>
          <c:idx val="2"/>
          <c:order val="2"/>
          <c:tx>
            <c:strRef>
              <c:f>'w1118 Female + Chol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w1118 Female + Chol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Choline'!$B$74:$AA$74</c:f>
              <c:numCache>
                <c:formatCode>General</c:formatCode>
                <c:ptCount val="26"/>
                <c:pt idx="0">
                  <c:v>100</c:v>
                </c:pt>
                <c:pt idx="1">
                  <c:v>100</c:v>
                </c:pt>
                <c:pt idx="2">
                  <c:v>96.92307692307692</c:v>
                </c:pt>
                <c:pt idx="3">
                  <c:v>96.410256410256409</c:v>
                </c:pt>
                <c:pt idx="4">
                  <c:v>94.358974358974365</c:v>
                </c:pt>
                <c:pt idx="5">
                  <c:v>92.307692307692307</c:v>
                </c:pt>
                <c:pt idx="6">
                  <c:v>92.307692307692307</c:v>
                </c:pt>
                <c:pt idx="7">
                  <c:v>91.282051282051285</c:v>
                </c:pt>
                <c:pt idx="8">
                  <c:v>86.666666666666671</c:v>
                </c:pt>
                <c:pt idx="9">
                  <c:v>84.102564102564102</c:v>
                </c:pt>
                <c:pt idx="10">
                  <c:v>83.07692307692308</c:v>
                </c:pt>
                <c:pt idx="11">
                  <c:v>77.948717948717956</c:v>
                </c:pt>
                <c:pt idx="12">
                  <c:v>71.282051282051285</c:v>
                </c:pt>
                <c:pt idx="13">
                  <c:v>66.666666666666671</c:v>
                </c:pt>
                <c:pt idx="14">
                  <c:v>57.948717948717949</c:v>
                </c:pt>
                <c:pt idx="15">
                  <c:v>51.794871794871796</c:v>
                </c:pt>
                <c:pt idx="16">
                  <c:v>44.102564102564102</c:v>
                </c:pt>
                <c:pt idx="17">
                  <c:v>37.435897435897438</c:v>
                </c:pt>
                <c:pt idx="18">
                  <c:v>30.769230769230774</c:v>
                </c:pt>
                <c:pt idx="19">
                  <c:v>23.589743589743591</c:v>
                </c:pt>
                <c:pt idx="20">
                  <c:v>12.307692307692307</c:v>
                </c:pt>
                <c:pt idx="21">
                  <c:v>8.7179487179487154</c:v>
                </c:pt>
                <c:pt idx="22">
                  <c:v>4.1025641025641022</c:v>
                </c:pt>
                <c:pt idx="23">
                  <c:v>0.512820512820511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4AE-4AFF-937F-9CC790D72732}"/>
            </c:ext>
          </c:extLst>
        </c:ser>
        <c:ser>
          <c:idx val="3"/>
          <c:order val="3"/>
          <c:tx>
            <c:strRef>
              <c:f>'w1118 Female + Chol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w1118 Female + Chol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Choline'!$B$75:$AA$75</c:f>
              <c:numCache>
                <c:formatCode>General</c:formatCode>
                <c:ptCount val="26"/>
                <c:pt idx="0">
                  <c:v>100</c:v>
                </c:pt>
                <c:pt idx="1">
                  <c:v>98.514851485148512</c:v>
                </c:pt>
                <c:pt idx="2">
                  <c:v>96.534653465346537</c:v>
                </c:pt>
                <c:pt idx="3">
                  <c:v>95.544554455445549</c:v>
                </c:pt>
                <c:pt idx="4">
                  <c:v>94.554455445544548</c:v>
                </c:pt>
                <c:pt idx="5">
                  <c:v>92.079207920792072</c:v>
                </c:pt>
                <c:pt idx="6">
                  <c:v>91.584158415841586</c:v>
                </c:pt>
                <c:pt idx="7">
                  <c:v>91.089108910891085</c:v>
                </c:pt>
                <c:pt idx="8">
                  <c:v>88.613861386138609</c:v>
                </c:pt>
                <c:pt idx="9">
                  <c:v>86.633663366336634</c:v>
                </c:pt>
                <c:pt idx="10">
                  <c:v>83.168316831683171</c:v>
                </c:pt>
                <c:pt idx="11">
                  <c:v>75.742574257425744</c:v>
                </c:pt>
                <c:pt idx="12">
                  <c:v>66.831683168316829</c:v>
                </c:pt>
                <c:pt idx="13">
                  <c:v>61.386138613861384</c:v>
                </c:pt>
                <c:pt idx="14">
                  <c:v>48.019801980198018</c:v>
                </c:pt>
                <c:pt idx="15">
                  <c:v>45.544554455445542</c:v>
                </c:pt>
                <c:pt idx="16">
                  <c:v>39.10891089108911</c:v>
                </c:pt>
                <c:pt idx="17">
                  <c:v>28.712871287128721</c:v>
                </c:pt>
                <c:pt idx="18">
                  <c:v>19.801980198019791</c:v>
                </c:pt>
                <c:pt idx="19">
                  <c:v>14.356435643564353</c:v>
                </c:pt>
                <c:pt idx="20">
                  <c:v>7.425742574257427</c:v>
                </c:pt>
                <c:pt idx="21">
                  <c:v>6.4356435643564254</c:v>
                </c:pt>
                <c:pt idx="22">
                  <c:v>4.4554455445544647</c:v>
                </c:pt>
                <c:pt idx="23">
                  <c:v>3.4653465346534631</c:v>
                </c:pt>
                <c:pt idx="24">
                  <c:v>1.9801980198019749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4AE-4AFF-937F-9CC790D72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w1118 Males + Chol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Male + Chol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Male + Chol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Choline'!$B$72:$AB$72</c:f>
              <c:numCache>
                <c:formatCode>General</c:formatCode>
                <c:ptCount val="27"/>
                <c:pt idx="0">
                  <c:v>100</c:v>
                </c:pt>
                <c:pt idx="1">
                  <c:v>100</c:v>
                </c:pt>
                <c:pt idx="2">
                  <c:v>95.081967213114751</c:v>
                </c:pt>
                <c:pt idx="3">
                  <c:v>94.535519125683066</c:v>
                </c:pt>
                <c:pt idx="4">
                  <c:v>93.442622950819668</c:v>
                </c:pt>
                <c:pt idx="5">
                  <c:v>91.803278688524586</c:v>
                </c:pt>
                <c:pt idx="6">
                  <c:v>90.710382513661202</c:v>
                </c:pt>
                <c:pt idx="7">
                  <c:v>89.071038251366119</c:v>
                </c:pt>
                <c:pt idx="8">
                  <c:v>86.885245901639337</c:v>
                </c:pt>
                <c:pt idx="9">
                  <c:v>84.15300546448087</c:v>
                </c:pt>
                <c:pt idx="10">
                  <c:v>82.513661202185787</c:v>
                </c:pt>
                <c:pt idx="11">
                  <c:v>73.770491803278688</c:v>
                </c:pt>
                <c:pt idx="12">
                  <c:v>71.038251366120221</c:v>
                </c:pt>
                <c:pt idx="13">
                  <c:v>66.666666666666671</c:v>
                </c:pt>
                <c:pt idx="14">
                  <c:v>37.704918032786885</c:v>
                </c:pt>
                <c:pt idx="15">
                  <c:v>33.879781420765028</c:v>
                </c:pt>
                <c:pt idx="16">
                  <c:v>28.961748633879779</c:v>
                </c:pt>
                <c:pt idx="17">
                  <c:v>14.207650273224047</c:v>
                </c:pt>
                <c:pt idx="18">
                  <c:v>13.114754098360663</c:v>
                </c:pt>
                <c:pt idx="19">
                  <c:v>10.928961748633881</c:v>
                </c:pt>
                <c:pt idx="20">
                  <c:v>3.2786885245901658</c:v>
                </c:pt>
                <c:pt idx="21">
                  <c:v>1.6393442622950829</c:v>
                </c:pt>
                <c:pt idx="22">
                  <c:v>1.6393442622950829</c:v>
                </c:pt>
                <c:pt idx="23">
                  <c:v>1.6393442622950829</c:v>
                </c:pt>
                <c:pt idx="24">
                  <c:v>1.6393442622950829</c:v>
                </c:pt>
                <c:pt idx="25">
                  <c:v>1.0928961748633839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B81-449A-B45B-E4F27757BAC5}"/>
            </c:ext>
          </c:extLst>
        </c:ser>
        <c:ser>
          <c:idx val="1"/>
          <c:order val="1"/>
          <c:tx>
            <c:strRef>
              <c:f>'w1118 Male + Chol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Male + Chol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Choline'!$B$73:$AB$73</c:f>
              <c:numCache>
                <c:formatCode>General</c:formatCode>
                <c:ptCount val="27"/>
                <c:pt idx="0">
                  <c:v>100</c:v>
                </c:pt>
                <c:pt idx="1">
                  <c:v>97.989949748743726</c:v>
                </c:pt>
                <c:pt idx="2">
                  <c:v>95.979899497487438</c:v>
                </c:pt>
                <c:pt idx="3">
                  <c:v>94.472361809045225</c:v>
                </c:pt>
                <c:pt idx="4">
                  <c:v>92.964824120603012</c:v>
                </c:pt>
                <c:pt idx="5">
                  <c:v>91.457286432160799</c:v>
                </c:pt>
                <c:pt idx="6">
                  <c:v>89.949748743718587</c:v>
                </c:pt>
                <c:pt idx="7">
                  <c:v>89.447236180904525</c:v>
                </c:pt>
                <c:pt idx="8">
                  <c:v>87.939698492462313</c:v>
                </c:pt>
                <c:pt idx="9">
                  <c:v>86.934673366834176</c:v>
                </c:pt>
                <c:pt idx="10">
                  <c:v>85.427135678391963</c:v>
                </c:pt>
                <c:pt idx="11">
                  <c:v>82.412060301507537</c:v>
                </c:pt>
                <c:pt idx="12">
                  <c:v>79.899497487437188</c:v>
                </c:pt>
                <c:pt idx="13">
                  <c:v>79.899497487437188</c:v>
                </c:pt>
                <c:pt idx="14">
                  <c:v>16.08040201005025</c:v>
                </c:pt>
                <c:pt idx="15">
                  <c:v>14.070351758793976</c:v>
                </c:pt>
                <c:pt idx="16">
                  <c:v>13.5678391959799</c:v>
                </c:pt>
                <c:pt idx="17">
                  <c:v>12.562814070351763</c:v>
                </c:pt>
                <c:pt idx="18">
                  <c:v>11.557788944723612</c:v>
                </c:pt>
                <c:pt idx="19">
                  <c:v>10.050251256281399</c:v>
                </c:pt>
                <c:pt idx="20">
                  <c:v>5.5276381909547752</c:v>
                </c:pt>
                <c:pt idx="21">
                  <c:v>5.0251256281406995</c:v>
                </c:pt>
                <c:pt idx="22">
                  <c:v>4.0201005025125625</c:v>
                </c:pt>
                <c:pt idx="23">
                  <c:v>1.0050251256281513</c:v>
                </c:pt>
                <c:pt idx="24">
                  <c:v>1.0050251256281513</c:v>
                </c:pt>
                <c:pt idx="25">
                  <c:v>1.0050251256281513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B81-449A-B45B-E4F27757BAC5}"/>
            </c:ext>
          </c:extLst>
        </c:ser>
        <c:ser>
          <c:idx val="2"/>
          <c:order val="2"/>
          <c:tx>
            <c:strRef>
              <c:f>'w1118 Male + Chol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w1118 Male + Chol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Choline'!$B$74:$AB$74</c:f>
              <c:numCache>
                <c:formatCode>General</c:formatCode>
                <c:ptCount val="27"/>
                <c:pt idx="0">
                  <c:v>100</c:v>
                </c:pt>
                <c:pt idx="1">
                  <c:v>99.438202247191015</c:v>
                </c:pt>
                <c:pt idx="2">
                  <c:v>94.382022471910119</c:v>
                </c:pt>
                <c:pt idx="3">
                  <c:v>92.696629213483149</c:v>
                </c:pt>
                <c:pt idx="4">
                  <c:v>90.449438202247194</c:v>
                </c:pt>
                <c:pt idx="5">
                  <c:v>87.640449438202253</c:v>
                </c:pt>
                <c:pt idx="6">
                  <c:v>85.393258426966298</c:v>
                </c:pt>
                <c:pt idx="7">
                  <c:v>85.393258426966298</c:v>
                </c:pt>
                <c:pt idx="8">
                  <c:v>83.146067415730329</c:v>
                </c:pt>
                <c:pt idx="9">
                  <c:v>80.337078651685388</c:v>
                </c:pt>
                <c:pt idx="10">
                  <c:v>78.089887640449433</c:v>
                </c:pt>
                <c:pt idx="11">
                  <c:v>69.101123595505612</c:v>
                </c:pt>
                <c:pt idx="12">
                  <c:v>62.359550561797754</c:v>
                </c:pt>
                <c:pt idx="13">
                  <c:v>61.797752808988768</c:v>
                </c:pt>
                <c:pt idx="14">
                  <c:v>47.19101123595506</c:v>
                </c:pt>
                <c:pt idx="15">
                  <c:v>43.82022471910112</c:v>
                </c:pt>
                <c:pt idx="16">
                  <c:v>40.449438202247187</c:v>
                </c:pt>
                <c:pt idx="17">
                  <c:v>17.977528089887642</c:v>
                </c:pt>
                <c:pt idx="18">
                  <c:v>15.730337078651687</c:v>
                </c:pt>
                <c:pt idx="19">
                  <c:v>13.483146067415731</c:v>
                </c:pt>
                <c:pt idx="20">
                  <c:v>3.3707865168539257</c:v>
                </c:pt>
                <c:pt idx="21">
                  <c:v>3.3707865168539257</c:v>
                </c:pt>
                <c:pt idx="22">
                  <c:v>2.8089887640449405</c:v>
                </c:pt>
                <c:pt idx="23">
                  <c:v>0.56179775280898525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B81-449A-B45B-E4F27757BAC5}"/>
            </c:ext>
          </c:extLst>
        </c:ser>
        <c:ser>
          <c:idx val="3"/>
          <c:order val="3"/>
          <c:tx>
            <c:strRef>
              <c:f>'w1118 Male + Chol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w1118 Male + Chol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Choline'!$B$75:$AB$75</c:f>
              <c:numCache>
                <c:formatCode>General</c:formatCode>
                <c:ptCount val="27"/>
                <c:pt idx="0">
                  <c:v>100</c:v>
                </c:pt>
                <c:pt idx="1">
                  <c:v>97.916666666666671</c:v>
                </c:pt>
                <c:pt idx="2">
                  <c:v>94.791666666666671</c:v>
                </c:pt>
                <c:pt idx="3">
                  <c:v>92.708333333333329</c:v>
                </c:pt>
                <c:pt idx="4">
                  <c:v>91.145833333333329</c:v>
                </c:pt>
                <c:pt idx="5">
                  <c:v>91.145833333333329</c:v>
                </c:pt>
                <c:pt idx="6">
                  <c:v>90.104166666666671</c:v>
                </c:pt>
                <c:pt idx="7">
                  <c:v>89.583333333333329</c:v>
                </c:pt>
                <c:pt idx="8">
                  <c:v>88.020833333333329</c:v>
                </c:pt>
                <c:pt idx="9">
                  <c:v>86.458333333333329</c:v>
                </c:pt>
                <c:pt idx="10">
                  <c:v>83.333333333333343</c:v>
                </c:pt>
                <c:pt idx="11">
                  <c:v>76.5625</c:v>
                </c:pt>
                <c:pt idx="12">
                  <c:v>73.4375</c:v>
                </c:pt>
                <c:pt idx="13">
                  <c:v>72.395833333333329</c:v>
                </c:pt>
                <c:pt idx="14">
                  <c:v>48.4375</c:v>
                </c:pt>
                <c:pt idx="15">
                  <c:v>44.270833333333336</c:v>
                </c:pt>
                <c:pt idx="16">
                  <c:v>40.104166666666664</c:v>
                </c:pt>
                <c:pt idx="17">
                  <c:v>25</c:v>
                </c:pt>
                <c:pt idx="18">
                  <c:v>19.791666666666657</c:v>
                </c:pt>
                <c:pt idx="19">
                  <c:v>17.708333333333343</c:v>
                </c:pt>
                <c:pt idx="20">
                  <c:v>10.9375</c:v>
                </c:pt>
                <c:pt idx="21">
                  <c:v>9.8958333333333428</c:v>
                </c:pt>
                <c:pt idx="22">
                  <c:v>8.3333333333333428</c:v>
                </c:pt>
                <c:pt idx="23">
                  <c:v>3.6458333333333428</c:v>
                </c:pt>
                <c:pt idx="24">
                  <c:v>2.6041666666666572</c:v>
                </c:pt>
                <c:pt idx="25">
                  <c:v>1.5625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B81-449A-B45B-E4F27757BA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Canton S Females + Histid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Female + Histid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anton S Fe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Female + Histidine'!$B$72:$AE$72</c:f>
              <c:numCache>
                <c:formatCode>General</c:formatCode>
                <c:ptCount val="30"/>
                <c:pt idx="0">
                  <c:v>100</c:v>
                </c:pt>
                <c:pt idx="1">
                  <c:v>99.5</c:v>
                </c:pt>
                <c:pt idx="2">
                  <c:v>99.5</c:v>
                </c:pt>
                <c:pt idx="3">
                  <c:v>98</c:v>
                </c:pt>
                <c:pt idx="4">
                  <c:v>97.5</c:v>
                </c:pt>
                <c:pt idx="5">
                  <c:v>96.5</c:v>
                </c:pt>
                <c:pt idx="6">
                  <c:v>95.5</c:v>
                </c:pt>
                <c:pt idx="7">
                  <c:v>94.5</c:v>
                </c:pt>
                <c:pt idx="8">
                  <c:v>93</c:v>
                </c:pt>
                <c:pt idx="9">
                  <c:v>91</c:v>
                </c:pt>
                <c:pt idx="10">
                  <c:v>89</c:v>
                </c:pt>
                <c:pt idx="11">
                  <c:v>87</c:v>
                </c:pt>
                <c:pt idx="12">
                  <c:v>86.5</c:v>
                </c:pt>
                <c:pt idx="13">
                  <c:v>85</c:v>
                </c:pt>
                <c:pt idx="14">
                  <c:v>76.5</c:v>
                </c:pt>
                <c:pt idx="15">
                  <c:v>73</c:v>
                </c:pt>
                <c:pt idx="16">
                  <c:v>70.5</c:v>
                </c:pt>
                <c:pt idx="17">
                  <c:v>61</c:v>
                </c:pt>
                <c:pt idx="18">
                  <c:v>58</c:v>
                </c:pt>
                <c:pt idx="19">
                  <c:v>54</c:v>
                </c:pt>
                <c:pt idx="20">
                  <c:v>47</c:v>
                </c:pt>
                <c:pt idx="21">
                  <c:v>38</c:v>
                </c:pt>
                <c:pt idx="22">
                  <c:v>31</c:v>
                </c:pt>
                <c:pt idx="23">
                  <c:v>24.5</c:v>
                </c:pt>
                <c:pt idx="24">
                  <c:v>18.5</c:v>
                </c:pt>
                <c:pt idx="25">
                  <c:v>14</c:v>
                </c:pt>
                <c:pt idx="26">
                  <c:v>4.5</c:v>
                </c:pt>
                <c:pt idx="27">
                  <c:v>2.5</c:v>
                </c:pt>
                <c:pt idx="28">
                  <c:v>2</c:v>
                </c:pt>
                <c:pt idx="29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747-4EDC-9D37-5A187E74FEA2}"/>
            </c:ext>
          </c:extLst>
        </c:ser>
        <c:ser>
          <c:idx val="1"/>
          <c:order val="1"/>
          <c:tx>
            <c:strRef>
              <c:f>'Canton S Female + Histid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Fe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Female + Histidine'!$B$73:$AE$73</c:f>
              <c:numCache>
                <c:formatCode>General</c:formatCode>
                <c:ptCount val="30"/>
                <c:pt idx="0">
                  <c:v>100</c:v>
                </c:pt>
                <c:pt idx="1">
                  <c:v>99.415204678362571</c:v>
                </c:pt>
                <c:pt idx="2">
                  <c:v>99.415204678362571</c:v>
                </c:pt>
                <c:pt idx="3">
                  <c:v>97.076023391812868</c:v>
                </c:pt>
                <c:pt idx="4">
                  <c:v>95.32163742690058</c:v>
                </c:pt>
                <c:pt idx="5">
                  <c:v>93.567251461988306</c:v>
                </c:pt>
                <c:pt idx="6">
                  <c:v>93.567251461988306</c:v>
                </c:pt>
                <c:pt idx="7">
                  <c:v>92.397660818713447</c:v>
                </c:pt>
                <c:pt idx="8">
                  <c:v>92.397660818713447</c:v>
                </c:pt>
                <c:pt idx="9">
                  <c:v>91.228070175438603</c:v>
                </c:pt>
                <c:pt idx="10">
                  <c:v>89.473684210526315</c:v>
                </c:pt>
                <c:pt idx="11">
                  <c:v>86.549707602339183</c:v>
                </c:pt>
                <c:pt idx="12">
                  <c:v>84.795321637426895</c:v>
                </c:pt>
                <c:pt idx="13">
                  <c:v>83.040935672514621</c:v>
                </c:pt>
                <c:pt idx="14">
                  <c:v>78.94736842105263</c:v>
                </c:pt>
                <c:pt idx="15">
                  <c:v>76.608187134502927</c:v>
                </c:pt>
                <c:pt idx="16">
                  <c:v>74.269005847953224</c:v>
                </c:pt>
                <c:pt idx="17">
                  <c:v>70.760233918128648</c:v>
                </c:pt>
                <c:pt idx="18">
                  <c:v>64.327485380116968</c:v>
                </c:pt>
                <c:pt idx="19">
                  <c:v>59.649122807017548</c:v>
                </c:pt>
                <c:pt idx="20">
                  <c:v>49.707602339181292</c:v>
                </c:pt>
                <c:pt idx="21">
                  <c:v>44.444444444444443</c:v>
                </c:pt>
                <c:pt idx="22">
                  <c:v>42.105263157894733</c:v>
                </c:pt>
                <c:pt idx="23">
                  <c:v>31.578947368421055</c:v>
                </c:pt>
                <c:pt idx="24">
                  <c:v>26.31578947368422</c:v>
                </c:pt>
                <c:pt idx="25">
                  <c:v>19.883040935672511</c:v>
                </c:pt>
                <c:pt idx="26">
                  <c:v>12.280701754385973</c:v>
                </c:pt>
                <c:pt idx="27">
                  <c:v>5.8479532163742647</c:v>
                </c:pt>
                <c:pt idx="28">
                  <c:v>3.5087719298245617</c:v>
                </c:pt>
                <c:pt idx="29">
                  <c:v>1.16959064327485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747-4EDC-9D37-5A187E74FEA2}"/>
            </c:ext>
          </c:extLst>
        </c:ser>
        <c:ser>
          <c:idx val="2"/>
          <c:order val="2"/>
          <c:tx>
            <c:strRef>
              <c:f>'Canton S Female + Histid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Canton S Fe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Female + Histidine'!$B$74:$AE$74</c:f>
              <c:numCache>
                <c:formatCode>General</c:formatCode>
                <c:ptCount val="3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4.897959183673464</c:v>
                </c:pt>
                <c:pt idx="4">
                  <c:v>92.857142857142861</c:v>
                </c:pt>
                <c:pt idx="5">
                  <c:v>91.836734693877546</c:v>
                </c:pt>
                <c:pt idx="6">
                  <c:v>90.816326530612244</c:v>
                </c:pt>
                <c:pt idx="7">
                  <c:v>90.306122448979593</c:v>
                </c:pt>
                <c:pt idx="8">
                  <c:v>90.306122448979593</c:v>
                </c:pt>
                <c:pt idx="9">
                  <c:v>86.224489795918373</c:v>
                </c:pt>
                <c:pt idx="10">
                  <c:v>83.673469387755105</c:v>
                </c:pt>
                <c:pt idx="11">
                  <c:v>79.08163265306122</c:v>
                </c:pt>
                <c:pt idx="12">
                  <c:v>77.040816326530603</c:v>
                </c:pt>
                <c:pt idx="13">
                  <c:v>71.428571428571431</c:v>
                </c:pt>
                <c:pt idx="14">
                  <c:v>58.673469387755098</c:v>
                </c:pt>
                <c:pt idx="15">
                  <c:v>54.591836734693878</c:v>
                </c:pt>
                <c:pt idx="16">
                  <c:v>50</c:v>
                </c:pt>
                <c:pt idx="17">
                  <c:v>37.244897959183675</c:v>
                </c:pt>
                <c:pt idx="18">
                  <c:v>31.632653061224488</c:v>
                </c:pt>
                <c:pt idx="19">
                  <c:v>21.428571428571431</c:v>
                </c:pt>
                <c:pt idx="20">
                  <c:v>17.346938775510196</c:v>
                </c:pt>
                <c:pt idx="21">
                  <c:v>13.775510204081627</c:v>
                </c:pt>
                <c:pt idx="22">
                  <c:v>11.734693877551024</c:v>
                </c:pt>
                <c:pt idx="23">
                  <c:v>9.183673469387756</c:v>
                </c:pt>
                <c:pt idx="24">
                  <c:v>6.1224489795918373</c:v>
                </c:pt>
                <c:pt idx="25">
                  <c:v>2.040816326530617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747-4EDC-9D37-5A187E74FEA2}"/>
            </c:ext>
          </c:extLst>
        </c:ser>
        <c:ser>
          <c:idx val="3"/>
          <c:order val="3"/>
          <c:tx>
            <c:strRef>
              <c:f>'Canton S Female + Histid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Canton S Fe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Female + Histidine'!$B$75:$AE$75</c:f>
              <c:numCache>
                <c:formatCode>General</c:formatCode>
                <c:ptCount val="3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7.409326424870471</c:v>
                </c:pt>
                <c:pt idx="4">
                  <c:v>96.373056994818654</c:v>
                </c:pt>
                <c:pt idx="5">
                  <c:v>95.854922279792746</c:v>
                </c:pt>
                <c:pt idx="6">
                  <c:v>93.782383419689126</c:v>
                </c:pt>
                <c:pt idx="7">
                  <c:v>93.264248704663217</c:v>
                </c:pt>
                <c:pt idx="8">
                  <c:v>90.673575129533674</c:v>
                </c:pt>
                <c:pt idx="9">
                  <c:v>88.601036269430054</c:v>
                </c:pt>
                <c:pt idx="10">
                  <c:v>88.601036269430054</c:v>
                </c:pt>
                <c:pt idx="11">
                  <c:v>88.082901554404145</c:v>
                </c:pt>
                <c:pt idx="12">
                  <c:v>86.010362694300511</c:v>
                </c:pt>
                <c:pt idx="13">
                  <c:v>82.901554404145074</c:v>
                </c:pt>
                <c:pt idx="14">
                  <c:v>72.020725388601036</c:v>
                </c:pt>
                <c:pt idx="15">
                  <c:v>69.948186528497416</c:v>
                </c:pt>
                <c:pt idx="16">
                  <c:v>64.248704663212436</c:v>
                </c:pt>
                <c:pt idx="17">
                  <c:v>53.8860103626943</c:v>
                </c:pt>
                <c:pt idx="18">
                  <c:v>47.668393782383426</c:v>
                </c:pt>
                <c:pt idx="19">
                  <c:v>39.37823834196891</c:v>
                </c:pt>
                <c:pt idx="20">
                  <c:v>29.533678756476689</c:v>
                </c:pt>
                <c:pt idx="21">
                  <c:v>25.388601036269435</c:v>
                </c:pt>
                <c:pt idx="22">
                  <c:v>18.134715025906729</c:v>
                </c:pt>
                <c:pt idx="23">
                  <c:v>14.507772020725383</c:v>
                </c:pt>
                <c:pt idx="24">
                  <c:v>9.8445595854922345</c:v>
                </c:pt>
                <c:pt idx="25">
                  <c:v>4.663212435233163</c:v>
                </c:pt>
                <c:pt idx="26">
                  <c:v>2.5906735751295287</c:v>
                </c:pt>
                <c:pt idx="27">
                  <c:v>1.0362694300518172</c:v>
                </c:pt>
                <c:pt idx="28">
                  <c:v>0.51813471502590858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747-4EDC-9D37-5A187E74FE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Canton S Males + Histid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Male + Histid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anton S 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Histidine'!$B$72:$AE$72</c:f>
              <c:numCache>
                <c:formatCode>General</c:formatCode>
                <c:ptCount val="3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9.5</c:v>
                </c:pt>
                <c:pt idx="4">
                  <c:v>99.5</c:v>
                </c:pt>
                <c:pt idx="5">
                  <c:v>99</c:v>
                </c:pt>
                <c:pt idx="6">
                  <c:v>99</c:v>
                </c:pt>
                <c:pt idx="7">
                  <c:v>98.5</c:v>
                </c:pt>
                <c:pt idx="8">
                  <c:v>98</c:v>
                </c:pt>
                <c:pt idx="9">
                  <c:v>96.5</c:v>
                </c:pt>
                <c:pt idx="10">
                  <c:v>96</c:v>
                </c:pt>
                <c:pt idx="11">
                  <c:v>96</c:v>
                </c:pt>
                <c:pt idx="12">
                  <c:v>95</c:v>
                </c:pt>
                <c:pt idx="13">
                  <c:v>92</c:v>
                </c:pt>
                <c:pt idx="14">
                  <c:v>86</c:v>
                </c:pt>
                <c:pt idx="15">
                  <c:v>83.5</c:v>
                </c:pt>
                <c:pt idx="16">
                  <c:v>80</c:v>
                </c:pt>
                <c:pt idx="17">
                  <c:v>67.5</c:v>
                </c:pt>
                <c:pt idx="18">
                  <c:v>58.5</c:v>
                </c:pt>
                <c:pt idx="19">
                  <c:v>52.5</c:v>
                </c:pt>
                <c:pt idx="20">
                  <c:v>37.5</c:v>
                </c:pt>
                <c:pt idx="21">
                  <c:v>26.5</c:v>
                </c:pt>
                <c:pt idx="22">
                  <c:v>18.5</c:v>
                </c:pt>
                <c:pt idx="23">
                  <c:v>14</c:v>
                </c:pt>
                <c:pt idx="24">
                  <c:v>8</c:v>
                </c:pt>
                <c:pt idx="25">
                  <c:v>6</c:v>
                </c:pt>
                <c:pt idx="26">
                  <c:v>3.5</c:v>
                </c:pt>
                <c:pt idx="27">
                  <c:v>3.5</c:v>
                </c:pt>
                <c:pt idx="28">
                  <c:v>1.5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6CE-4848-BA0A-87F596DB1129}"/>
            </c:ext>
          </c:extLst>
        </c:ser>
        <c:ser>
          <c:idx val="1"/>
          <c:order val="1"/>
          <c:tx>
            <c:strRef>
              <c:f>'Canton S Male + Histid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Histidine'!$B$73:$AE$73</c:f>
              <c:numCache>
                <c:formatCode>General</c:formatCode>
                <c:ptCount val="30"/>
                <c:pt idx="0">
                  <c:v>100</c:v>
                </c:pt>
                <c:pt idx="1">
                  <c:v>99.492385786802032</c:v>
                </c:pt>
                <c:pt idx="2">
                  <c:v>98.984771573604064</c:v>
                </c:pt>
                <c:pt idx="3">
                  <c:v>97.969543147208128</c:v>
                </c:pt>
                <c:pt idx="4">
                  <c:v>97.461928934010146</c:v>
                </c:pt>
                <c:pt idx="5">
                  <c:v>97.461928934010146</c:v>
                </c:pt>
                <c:pt idx="6">
                  <c:v>96.954314720812178</c:v>
                </c:pt>
                <c:pt idx="7">
                  <c:v>96.44670050761421</c:v>
                </c:pt>
                <c:pt idx="8">
                  <c:v>95.939086294416242</c:v>
                </c:pt>
                <c:pt idx="9">
                  <c:v>95.939086294416242</c:v>
                </c:pt>
                <c:pt idx="10">
                  <c:v>92.89340101522842</c:v>
                </c:pt>
                <c:pt idx="11">
                  <c:v>91.370558375634516</c:v>
                </c:pt>
                <c:pt idx="12">
                  <c:v>89.847715736040612</c:v>
                </c:pt>
                <c:pt idx="13">
                  <c:v>87.309644670050758</c:v>
                </c:pt>
                <c:pt idx="14">
                  <c:v>80.710659898477161</c:v>
                </c:pt>
                <c:pt idx="15">
                  <c:v>74.111675126903549</c:v>
                </c:pt>
                <c:pt idx="16">
                  <c:v>70.558375634517773</c:v>
                </c:pt>
                <c:pt idx="17">
                  <c:v>64.467005076142129</c:v>
                </c:pt>
                <c:pt idx="18">
                  <c:v>55.837563451776653</c:v>
                </c:pt>
                <c:pt idx="19">
                  <c:v>47.715736040609137</c:v>
                </c:pt>
                <c:pt idx="20">
                  <c:v>39.086294416243646</c:v>
                </c:pt>
                <c:pt idx="21">
                  <c:v>32.994923857868017</c:v>
                </c:pt>
                <c:pt idx="22">
                  <c:v>26.395939086294419</c:v>
                </c:pt>
                <c:pt idx="23">
                  <c:v>20.812182741116743</c:v>
                </c:pt>
                <c:pt idx="24">
                  <c:v>13.705583756345177</c:v>
                </c:pt>
                <c:pt idx="25">
                  <c:v>5.5837563451776617</c:v>
                </c:pt>
                <c:pt idx="26">
                  <c:v>0.50761421319796796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6CE-4848-BA0A-87F596DB1129}"/>
            </c:ext>
          </c:extLst>
        </c:ser>
        <c:ser>
          <c:idx val="2"/>
          <c:order val="2"/>
          <c:tx>
            <c:strRef>
              <c:f>'Canton S Male + Histid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Canton S 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Histidine'!$B$74:$AE$74</c:f>
              <c:numCache>
                <c:formatCode>General</c:formatCode>
                <c:ptCount val="3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98.5</c:v>
                </c:pt>
                <c:pt idx="6">
                  <c:v>98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</c:v>
                </c:pt>
                <c:pt idx="11">
                  <c:v>92</c:v>
                </c:pt>
                <c:pt idx="12">
                  <c:v>89.5</c:v>
                </c:pt>
                <c:pt idx="13">
                  <c:v>86.5</c:v>
                </c:pt>
                <c:pt idx="14">
                  <c:v>82.5</c:v>
                </c:pt>
                <c:pt idx="15">
                  <c:v>77.5</c:v>
                </c:pt>
                <c:pt idx="16">
                  <c:v>71.5</c:v>
                </c:pt>
                <c:pt idx="17">
                  <c:v>63.5</c:v>
                </c:pt>
                <c:pt idx="18">
                  <c:v>54.5</c:v>
                </c:pt>
                <c:pt idx="19">
                  <c:v>49</c:v>
                </c:pt>
                <c:pt idx="20">
                  <c:v>40.5</c:v>
                </c:pt>
                <c:pt idx="21">
                  <c:v>32.5</c:v>
                </c:pt>
                <c:pt idx="22">
                  <c:v>26</c:v>
                </c:pt>
                <c:pt idx="23">
                  <c:v>18</c:v>
                </c:pt>
                <c:pt idx="24">
                  <c:v>10.5</c:v>
                </c:pt>
                <c:pt idx="25">
                  <c:v>4</c:v>
                </c:pt>
                <c:pt idx="26">
                  <c:v>2</c:v>
                </c:pt>
                <c:pt idx="27">
                  <c:v>1</c:v>
                </c:pt>
                <c:pt idx="28">
                  <c:v>0.5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6CE-4848-BA0A-87F596DB1129}"/>
            </c:ext>
          </c:extLst>
        </c:ser>
        <c:ser>
          <c:idx val="3"/>
          <c:order val="3"/>
          <c:tx>
            <c:strRef>
              <c:f>'Canton S Male + Histid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Canton S Male + Histidin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Canton S Male + Histidine'!$B$75:$AE$75</c:f>
              <c:numCache>
                <c:formatCode>General</c:formatCode>
                <c:ptCount val="30"/>
                <c:pt idx="0">
                  <c:v>100</c:v>
                </c:pt>
                <c:pt idx="1">
                  <c:v>99.5</c:v>
                </c:pt>
                <c:pt idx="2">
                  <c:v>99</c:v>
                </c:pt>
                <c:pt idx="3">
                  <c:v>98.5</c:v>
                </c:pt>
                <c:pt idx="4">
                  <c:v>98</c:v>
                </c:pt>
                <c:pt idx="5">
                  <c:v>98</c:v>
                </c:pt>
                <c:pt idx="6">
                  <c:v>97.5</c:v>
                </c:pt>
                <c:pt idx="7">
                  <c:v>96</c:v>
                </c:pt>
                <c:pt idx="8">
                  <c:v>94</c:v>
                </c:pt>
                <c:pt idx="9">
                  <c:v>94</c:v>
                </c:pt>
                <c:pt idx="10">
                  <c:v>94</c:v>
                </c:pt>
                <c:pt idx="11">
                  <c:v>90</c:v>
                </c:pt>
                <c:pt idx="12">
                  <c:v>88</c:v>
                </c:pt>
                <c:pt idx="13">
                  <c:v>85</c:v>
                </c:pt>
                <c:pt idx="14">
                  <c:v>80.5</c:v>
                </c:pt>
                <c:pt idx="15">
                  <c:v>72</c:v>
                </c:pt>
                <c:pt idx="16">
                  <c:v>65.5</c:v>
                </c:pt>
                <c:pt idx="17">
                  <c:v>57.5</c:v>
                </c:pt>
                <c:pt idx="18">
                  <c:v>51</c:v>
                </c:pt>
                <c:pt idx="19">
                  <c:v>43.500000000000007</c:v>
                </c:pt>
                <c:pt idx="20">
                  <c:v>33</c:v>
                </c:pt>
                <c:pt idx="21">
                  <c:v>26</c:v>
                </c:pt>
                <c:pt idx="22">
                  <c:v>16.5</c:v>
                </c:pt>
                <c:pt idx="23">
                  <c:v>9.5</c:v>
                </c:pt>
                <c:pt idx="24">
                  <c:v>5.5</c:v>
                </c:pt>
                <c:pt idx="25">
                  <c:v>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6CE-4848-BA0A-87F596DB11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w1118 Females + Histid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Female + Histid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Female + Histid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Histidine'!$B$72:$AA$72</c:f>
              <c:numCache>
                <c:formatCode>General</c:formatCode>
                <c:ptCount val="26"/>
                <c:pt idx="0">
                  <c:v>100</c:v>
                </c:pt>
                <c:pt idx="1">
                  <c:v>98.369565217391298</c:v>
                </c:pt>
                <c:pt idx="2">
                  <c:v>94.565217391304344</c:v>
                </c:pt>
                <c:pt idx="3">
                  <c:v>92.934782608695656</c:v>
                </c:pt>
                <c:pt idx="4">
                  <c:v>92.934782608695656</c:v>
                </c:pt>
                <c:pt idx="5">
                  <c:v>91.304347826086953</c:v>
                </c:pt>
                <c:pt idx="6">
                  <c:v>91.304347826086953</c:v>
                </c:pt>
                <c:pt idx="7">
                  <c:v>89.673913043478265</c:v>
                </c:pt>
                <c:pt idx="8">
                  <c:v>88.043478260869563</c:v>
                </c:pt>
                <c:pt idx="9">
                  <c:v>86.956521739130437</c:v>
                </c:pt>
                <c:pt idx="10">
                  <c:v>82.608695652173907</c:v>
                </c:pt>
                <c:pt idx="11">
                  <c:v>77.173913043478265</c:v>
                </c:pt>
                <c:pt idx="12">
                  <c:v>72.282608695652172</c:v>
                </c:pt>
                <c:pt idx="13">
                  <c:v>66.304347826086953</c:v>
                </c:pt>
                <c:pt idx="14">
                  <c:v>57.608695652173914</c:v>
                </c:pt>
                <c:pt idx="15">
                  <c:v>53.260869565217391</c:v>
                </c:pt>
                <c:pt idx="16">
                  <c:v>46.739130434782602</c:v>
                </c:pt>
                <c:pt idx="17">
                  <c:v>36.413043478260867</c:v>
                </c:pt>
                <c:pt idx="18">
                  <c:v>29.347826086956516</c:v>
                </c:pt>
                <c:pt idx="19">
                  <c:v>24.456521739130437</c:v>
                </c:pt>
                <c:pt idx="20">
                  <c:v>16.304347826086953</c:v>
                </c:pt>
                <c:pt idx="21">
                  <c:v>9.2391304347826093</c:v>
                </c:pt>
                <c:pt idx="22">
                  <c:v>9.2391304347826093</c:v>
                </c:pt>
                <c:pt idx="23">
                  <c:v>5.9782608695652186</c:v>
                </c:pt>
                <c:pt idx="24">
                  <c:v>3.8043478260869534</c:v>
                </c:pt>
                <c:pt idx="25">
                  <c:v>1.63043478260868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238-48AD-83D9-B559FF6DFF6D}"/>
            </c:ext>
          </c:extLst>
        </c:ser>
        <c:ser>
          <c:idx val="1"/>
          <c:order val="1"/>
          <c:tx>
            <c:strRef>
              <c:f>'w1118 Female + Histid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Female + Histid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Histidine'!$B$73:$AA$73</c:f>
              <c:numCache>
                <c:formatCode>General</c:formatCode>
                <c:ptCount val="26"/>
                <c:pt idx="0">
                  <c:v>100</c:v>
                </c:pt>
                <c:pt idx="1">
                  <c:v>99.456521739130437</c:v>
                </c:pt>
                <c:pt idx="2">
                  <c:v>97.826086956521735</c:v>
                </c:pt>
                <c:pt idx="3">
                  <c:v>97.282608695652172</c:v>
                </c:pt>
                <c:pt idx="4">
                  <c:v>95.652173913043484</c:v>
                </c:pt>
                <c:pt idx="5">
                  <c:v>92.391304347826093</c:v>
                </c:pt>
                <c:pt idx="6">
                  <c:v>91.847826086956516</c:v>
                </c:pt>
                <c:pt idx="7">
                  <c:v>91.847826086956516</c:v>
                </c:pt>
                <c:pt idx="8">
                  <c:v>89.673913043478265</c:v>
                </c:pt>
                <c:pt idx="9">
                  <c:v>89.673913043478265</c:v>
                </c:pt>
                <c:pt idx="10">
                  <c:v>86.956521739130437</c:v>
                </c:pt>
                <c:pt idx="11">
                  <c:v>86.413043478260875</c:v>
                </c:pt>
                <c:pt idx="12">
                  <c:v>82.608695652173907</c:v>
                </c:pt>
                <c:pt idx="13">
                  <c:v>76.630434782608688</c:v>
                </c:pt>
                <c:pt idx="14">
                  <c:v>55.978260869565219</c:v>
                </c:pt>
                <c:pt idx="15">
                  <c:v>52.173913043478258</c:v>
                </c:pt>
                <c:pt idx="16">
                  <c:v>48.913043478260867</c:v>
                </c:pt>
                <c:pt idx="17">
                  <c:v>33.695652173913047</c:v>
                </c:pt>
                <c:pt idx="18">
                  <c:v>27.173913043478265</c:v>
                </c:pt>
                <c:pt idx="19">
                  <c:v>21.739130434782609</c:v>
                </c:pt>
                <c:pt idx="20">
                  <c:v>1.6304347826086882</c:v>
                </c:pt>
                <c:pt idx="21">
                  <c:v>0.54347826086956275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238-48AD-83D9-B559FF6DFF6D}"/>
            </c:ext>
          </c:extLst>
        </c:ser>
        <c:ser>
          <c:idx val="2"/>
          <c:order val="2"/>
          <c:tx>
            <c:strRef>
              <c:f>'w1118 Female + Histid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w1118 Female + Histid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Histidine'!$B$74:$AA$74</c:f>
              <c:numCache>
                <c:formatCode>General</c:formatCode>
                <c:ptCount val="26"/>
                <c:pt idx="0">
                  <c:v>100</c:v>
                </c:pt>
                <c:pt idx="1">
                  <c:v>98.536585365853654</c:v>
                </c:pt>
                <c:pt idx="2">
                  <c:v>97.560975609756099</c:v>
                </c:pt>
                <c:pt idx="3">
                  <c:v>94.634146341463421</c:v>
                </c:pt>
                <c:pt idx="4">
                  <c:v>94.634146341463421</c:v>
                </c:pt>
                <c:pt idx="5">
                  <c:v>91.707317073170728</c:v>
                </c:pt>
                <c:pt idx="6">
                  <c:v>90.731707317073173</c:v>
                </c:pt>
                <c:pt idx="7">
                  <c:v>88.780487804878049</c:v>
                </c:pt>
                <c:pt idx="8">
                  <c:v>86.829268292682926</c:v>
                </c:pt>
                <c:pt idx="9">
                  <c:v>84.878048780487802</c:v>
                </c:pt>
                <c:pt idx="10">
                  <c:v>82.439024390243901</c:v>
                </c:pt>
                <c:pt idx="11">
                  <c:v>79.512195121951223</c:v>
                </c:pt>
                <c:pt idx="12">
                  <c:v>77.073170731707307</c:v>
                </c:pt>
                <c:pt idx="13">
                  <c:v>72.682926829268297</c:v>
                </c:pt>
                <c:pt idx="14">
                  <c:v>61.463414634146339</c:v>
                </c:pt>
                <c:pt idx="15">
                  <c:v>47.317073170731703</c:v>
                </c:pt>
                <c:pt idx="16">
                  <c:v>37.560975609756099</c:v>
                </c:pt>
                <c:pt idx="17">
                  <c:v>22.926829268292678</c:v>
                </c:pt>
                <c:pt idx="18">
                  <c:v>17.560975609756099</c:v>
                </c:pt>
                <c:pt idx="19">
                  <c:v>12.682926829268297</c:v>
                </c:pt>
                <c:pt idx="20">
                  <c:v>7.3170731707317032</c:v>
                </c:pt>
                <c:pt idx="21">
                  <c:v>2.4390243902439011</c:v>
                </c:pt>
                <c:pt idx="22">
                  <c:v>0.48780487804877737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238-48AD-83D9-B559FF6DFF6D}"/>
            </c:ext>
          </c:extLst>
        </c:ser>
        <c:ser>
          <c:idx val="3"/>
          <c:order val="3"/>
          <c:tx>
            <c:strRef>
              <c:f>'w1118 Female + Histid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w1118 Female + Histidine'!$B$71:$AA$71</c:f>
              <c:numCache>
                <c:formatCode>0</c:formatCode>
                <c:ptCount val="26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</c:numCache>
            </c:numRef>
          </c:cat>
          <c:val>
            <c:numRef>
              <c:f>'w1118 Female + Histidine'!$B$75:$AA$75</c:f>
              <c:numCache>
                <c:formatCode>General</c:formatCode>
                <c:ptCount val="26"/>
                <c:pt idx="0">
                  <c:v>100</c:v>
                </c:pt>
                <c:pt idx="1">
                  <c:v>100</c:v>
                </c:pt>
                <c:pt idx="2">
                  <c:v>98.994974874371863</c:v>
                </c:pt>
                <c:pt idx="3">
                  <c:v>98.492462311557787</c:v>
                </c:pt>
                <c:pt idx="4">
                  <c:v>97.989949748743726</c:v>
                </c:pt>
                <c:pt idx="5">
                  <c:v>95.477386934673362</c:v>
                </c:pt>
                <c:pt idx="6">
                  <c:v>94.9748743718593</c:v>
                </c:pt>
                <c:pt idx="7">
                  <c:v>93.969849246231149</c:v>
                </c:pt>
                <c:pt idx="8">
                  <c:v>91.959798994974875</c:v>
                </c:pt>
                <c:pt idx="9">
                  <c:v>87.939698492462313</c:v>
                </c:pt>
                <c:pt idx="10">
                  <c:v>83.417085427135675</c:v>
                </c:pt>
                <c:pt idx="11">
                  <c:v>76.884422110552762</c:v>
                </c:pt>
                <c:pt idx="12">
                  <c:v>73.366834170854275</c:v>
                </c:pt>
                <c:pt idx="13">
                  <c:v>67.336683417085425</c:v>
                </c:pt>
                <c:pt idx="14">
                  <c:v>59.798994974874368</c:v>
                </c:pt>
                <c:pt idx="15">
                  <c:v>54.773869346733669</c:v>
                </c:pt>
                <c:pt idx="16">
                  <c:v>52.261306532663312</c:v>
                </c:pt>
                <c:pt idx="17">
                  <c:v>45.7286432160804</c:v>
                </c:pt>
                <c:pt idx="18">
                  <c:v>39.698492462311563</c:v>
                </c:pt>
                <c:pt idx="19">
                  <c:v>27.1356783919598</c:v>
                </c:pt>
                <c:pt idx="20">
                  <c:v>10.050251256281399</c:v>
                </c:pt>
                <c:pt idx="21">
                  <c:v>6.0301507537688508</c:v>
                </c:pt>
                <c:pt idx="22">
                  <c:v>3.0150753768844254</c:v>
                </c:pt>
                <c:pt idx="23">
                  <c:v>1.5075376884422127</c:v>
                </c:pt>
                <c:pt idx="24">
                  <c:v>0.50251256281407564</c:v>
                </c:pt>
                <c:pt idx="25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238-48AD-83D9-B559FF6DFF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w1118 Males + Histidin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Male + Histidine'!$A$72</c:f>
              <c:strCache>
                <c:ptCount val="1"/>
                <c:pt idx="0">
                  <c:v>0 mM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Male + Histid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Histidine'!$B$72:$AB$72</c:f>
              <c:numCache>
                <c:formatCode>General</c:formatCode>
                <c:ptCount val="27"/>
                <c:pt idx="0">
                  <c:v>100</c:v>
                </c:pt>
                <c:pt idx="1">
                  <c:v>100</c:v>
                </c:pt>
                <c:pt idx="2">
                  <c:v>95.054945054945051</c:v>
                </c:pt>
                <c:pt idx="3">
                  <c:v>94.505494505494511</c:v>
                </c:pt>
                <c:pt idx="4">
                  <c:v>93.406593406593402</c:v>
                </c:pt>
                <c:pt idx="5">
                  <c:v>91.758241758241752</c:v>
                </c:pt>
                <c:pt idx="6">
                  <c:v>90.659340659340657</c:v>
                </c:pt>
                <c:pt idx="7">
                  <c:v>89.010989010989007</c:v>
                </c:pt>
                <c:pt idx="8">
                  <c:v>86.813186813186817</c:v>
                </c:pt>
                <c:pt idx="9">
                  <c:v>84.065934065934073</c:v>
                </c:pt>
                <c:pt idx="10">
                  <c:v>82.417582417582423</c:v>
                </c:pt>
                <c:pt idx="11">
                  <c:v>73.626373626373621</c:v>
                </c:pt>
                <c:pt idx="12">
                  <c:v>70.879120879120876</c:v>
                </c:pt>
                <c:pt idx="13">
                  <c:v>66.483516483516496</c:v>
                </c:pt>
                <c:pt idx="14">
                  <c:v>37.362637362637365</c:v>
                </c:pt>
                <c:pt idx="15">
                  <c:v>33.516483516483518</c:v>
                </c:pt>
                <c:pt idx="16">
                  <c:v>28.571428571428569</c:v>
                </c:pt>
                <c:pt idx="17">
                  <c:v>13.736263736263737</c:v>
                </c:pt>
                <c:pt idx="18">
                  <c:v>12.637362637362642</c:v>
                </c:pt>
                <c:pt idx="19">
                  <c:v>10.439560439560438</c:v>
                </c:pt>
                <c:pt idx="20">
                  <c:v>2.7472527472527446</c:v>
                </c:pt>
                <c:pt idx="21">
                  <c:v>1.098901098901095</c:v>
                </c:pt>
                <c:pt idx="22">
                  <c:v>1.098901098901095</c:v>
                </c:pt>
                <c:pt idx="23">
                  <c:v>1.098901098901095</c:v>
                </c:pt>
                <c:pt idx="24">
                  <c:v>1.098901098901095</c:v>
                </c:pt>
                <c:pt idx="25">
                  <c:v>0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8DE-488B-BDB2-4846205E9859}"/>
            </c:ext>
          </c:extLst>
        </c:ser>
        <c:ser>
          <c:idx val="1"/>
          <c:order val="1"/>
          <c:tx>
            <c:strRef>
              <c:f>'w1118 Male + Histidine'!$A$73</c:f>
              <c:strCache>
                <c:ptCount val="1"/>
                <c:pt idx="0">
                  <c:v>1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Male + Histid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Histidine'!$B$73:$AB$73</c:f>
              <c:numCache>
                <c:formatCode>General</c:formatCode>
                <c:ptCount val="27"/>
                <c:pt idx="0">
                  <c:v>100</c:v>
                </c:pt>
                <c:pt idx="1">
                  <c:v>98.324022346368722</c:v>
                </c:pt>
                <c:pt idx="2">
                  <c:v>94.413407821229043</c:v>
                </c:pt>
                <c:pt idx="3">
                  <c:v>92.178770949720672</c:v>
                </c:pt>
                <c:pt idx="4">
                  <c:v>89.944134078212286</c:v>
                </c:pt>
                <c:pt idx="5">
                  <c:v>88.268156424581008</c:v>
                </c:pt>
                <c:pt idx="6">
                  <c:v>86.592178770949715</c:v>
                </c:pt>
                <c:pt idx="7">
                  <c:v>84.916201117318437</c:v>
                </c:pt>
                <c:pt idx="8">
                  <c:v>81.564245810055866</c:v>
                </c:pt>
                <c:pt idx="9">
                  <c:v>78.212290502793294</c:v>
                </c:pt>
                <c:pt idx="10">
                  <c:v>76.536312849162016</c:v>
                </c:pt>
                <c:pt idx="11">
                  <c:v>68.715083798882688</c:v>
                </c:pt>
                <c:pt idx="12">
                  <c:v>62.569832402234638</c:v>
                </c:pt>
                <c:pt idx="13">
                  <c:v>58.100558659217874</c:v>
                </c:pt>
                <c:pt idx="14">
                  <c:v>45.810055865921782</c:v>
                </c:pt>
                <c:pt idx="15">
                  <c:v>41.340782122905026</c:v>
                </c:pt>
                <c:pt idx="16">
                  <c:v>37.430167597765362</c:v>
                </c:pt>
                <c:pt idx="17">
                  <c:v>18.994413407821227</c:v>
                </c:pt>
                <c:pt idx="18">
                  <c:v>13.407821229050271</c:v>
                </c:pt>
                <c:pt idx="19">
                  <c:v>8.9385474860335279</c:v>
                </c:pt>
                <c:pt idx="20">
                  <c:v>1.6759776536312927</c:v>
                </c:pt>
                <c:pt idx="21">
                  <c:v>1.1173184357541857</c:v>
                </c:pt>
                <c:pt idx="22">
                  <c:v>1.1173184357541857</c:v>
                </c:pt>
                <c:pt idx="23">
                  <c:v>0.55865921787710704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8DE-488B-BDB2-4846205E9859}"/>
            </c:ext>
          </c:extLst>
        </c:ser>
        <c:ser>
          <c:idx val="2"/>
          <c:order val="2"/>
          <c:tx>
            <c:strRef>
              <c:f>'w1118 Male + Histidine'!$A$74</c:f>
              <c:strCache>
                <c:ptCount val="1"/>
                <c:pt idx="0">
                  <c:v>5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w1118 Male + Histid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Histidine'!$B$74:$AB$74</c:f>
              <c:numCache>
                <c:formatCode>General</c:formatCode>
                <c:ptCount val="27"/>
                <c:pt idx="0">
                  <c:v>100</c:v>
                </c:pt>
                <c:pt idx="1">
                  <c:v>98.98989898989899</c:v>
                </c:pt>
                <c:pt idx="2">
                  <c:v>94.444444444444443</c:v>
                </c:pt>
                <c:pt idx="3">
                  <c:v>93.434343434343432</c:v>
                </c:pt>
                <c:pt idx="4">
                  <c:v>90.404040404040401</c:v>
                </c:pt>
                <c:pt idx="5">
                  <c:v>88.383838383838381</c:v>
                </c:pt>
                <c:pt idx="6">
                  <c:v>87.878787878787875</c:v>
                </c:pt>
                <c:pt idx="7">
                  <c:v>86.868686868686865</c:v>
                </c:pt>
                <c:pt idx="8">
                  <c:v>84.848484848484844</c:v>
                </c:pt>
                <c:pt idx="9">
                  <c:v>83.838383838383834</c:v>
                </c:pt>
                <c:pt idx="10">
                  <c:v>78.787878787878782</c:v>
                </c:pt>
                <c:pt idx="11">
                  <c:v>67.171717171717177</c:v>
                </c:pt>
                <c:pt idx="12">
                  <c:v>57.575757575757578</c:v>
                </c:pt>
                <c:pt idx="13">
                  <c:v>52.525252525252526</c:v>
                </c:pt>
                <c:pt idx="14">
                  <c:v>37.37373737373737</c:v>
                </c:pt>
                <c:pt idx="15">
                  <c:v>34.848484848484844</c:v>
                </c:pt>
                <c:pt idx="16">
                  <c:v>31.313131313131322</c:v>
                </c:pt>
                <c:pt idx="17">
                  <c:v>14.141414141414145</c:v>
                </c:pt>
                <c:pt idx="18">
                  <c:v>12.121212121212125</c:v>
                </c:pt>
                <c:pt idx="19">
                  <c:v>8.0808080808080831</c:v>
                </c:pt>
                <c:pt idx="20">
                  <c:v>3.0303030303030312</c:v>
                </c:pt>
                <c:pt idx="21">
                  <c:v>2.525252525252526</c:v>
                </c:pt>
                <c:pt idx="22">
                  <c:v>2.525252525252526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8DE-488B-BDB2-4846205E9859}"/>
            </c:ext>
          </c:extLst>
        </c:ser>
        <c:ser>
          <c:idx val="3"/>
          <c:order val="3"/>
          <c:tx>
            <c:strRef>
              <c:f>'w1118 Male + Histidine'!$A$75</c:f>
              <c:strCache>
                <c:ptCount val="1"/>
                <c:pt idx="0">
                  <c:v>10 mM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w1118 Male + Histidine'!$B$71:$AB$71</c:f>
              <c:numCache>
                <c:formatCode>0</c:formatCode>
                <c:ptCount val="27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</c:numCache>
            </c:numRef>
          </c:cat>
          <c:val>
            <c:numRef>
              <c:f>'w1118 Male + Histidine'!$B$75:$AB$75</c:f>
              <c:numCache>
                <c:formatCode>General</c:formatCode>
                <c:ptCount val="27"/>
                <c:pt idx="0">
                  <c:v>100</c:v>
                </c:pt>
                <c:pt idx="1">
                  <c:v>98.984771573604064</c:v>
                </c:pt>
                <c:pt idx="2">
                  <c:v>94.923857868020306</c:v>
                </c:pt>
                <c:pt idx="3">
                  <c:v>93.90862944162437</c:v>
                </c:pt>
                <c:pt idx="4">
                  <c:v>93.401015228426388</c:v>
                </c:pt>
                <c:pt idx="5">
                  <c:v>91.878172588832484</c:v>
                </c:pt>
                <c:pt idx="6">
                  <c:v>91.370558375634516</c:v>
                </c:pt>
                <c:pt idx="7">
                  <c:v>89.847715736040612</c:v>
                </c:pt>
                <c:pt idx="8">
                  <c:v>86.294416243654823</c:v>
                </c:pt>
                <c:pt idx="9">
                  <c:v>83.248730964467001</c:v>
                </c:pt>
                <c:pt idx="10">
                  <c:v>81.218274111675129</c:v>
                </c:pt>
                <c:pt idx="11">
                  <c:v>66.497461928934001</c:v>
                </c:pt>
                <c:pt idx="12">
                  <c:v>60.913705583756347</c:v>
                </c:pt>
                <c:pt idx="13">
                  <c:v>56.852791878172589</c:v>
                </c:pt>
                <c:pt idx="14">
                  <c:v>40.101522842639589</c:v>
                </c:pt>
                <c:pt idx="15">
                  <c:v>36.548223350253807</c:v>
                </c:pt>
                <c:pt idx="16">
                  <c:v>32.994923857868017</c:v>
                </c:pt>
                <c:pt idx="17">
                  <c:v>14.720812182741113</c:v>
                </c:pt>
                <c:pt idx="18">
                  <c:v>12.182741116751274</c:v>
                </c:pt>
                <c:pt idx="19">
                  <c:v>9.1370558375634516</c:v>
                </c:pt>
                <c:pt idx="20">
                  <c:v>0.5076142131979679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8DE-488B-BDB2-4846205E98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w1118 Males + Orotat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w1118 M Orotat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w1118 M Orotat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w1118 M Orotate'!$B$72:$AD$72</c:f>
              <c:numCache>
                <c:formatCode>General</c:formatCode>
                <c:ptCount val="29"/>
                <c:pt idx="0">
                  <c:v>100</c:v>
                </c:pt>
                <c:pt idx="1">
                  <c:v>98.5</c:v>
                </c:pt>
                <c:pt idx="2">
                  <c:v>97</c:v>
                </c:pt>
                <c:pt idx="3">
                  <c:v>96</c:v>
                </c:pt>
                <c:pt idx="4">
                  <c:v>95.5</c:v>
                </c:pt>
                <c:pt idx="5">
                  <c:v>94</c:v>
                </c:pt>
                <c:pt idx="6">
                  <c:v>94</c:v>
                </c:pt>
                <c:pt idx="7">
                  <c:v>93.5</c:v>
                </c:pt>
                <c:pt idx="8">
                  <c:v>91.5</c:v>
                </c:pt>
                <c:pt idx="9">
                  <c:v>90.5</c:v>
                </c:pt>
                <c:pt idx="10">
                  <c:v>89</c:v>
                </c:pt>
                <c:pt idx="11">
                  <c:v>85</c:v>
                </c:pt>
                <c:pt idx="12">
                  <c:v>83</c:v>
                </c:pt>
                <c:pt idx="13">
                  <c:v>80</c:v>
                </c:pt>
                <c:pt idx="14">
                  <c:v>79</c:v>
                </c:pt>
                <c:pt idx="15">
                  <c:v>76</c:v>
                </c:pt>
                <c:pt idx="16">
                  <c:v>68.5</c:v>
                </c:pt>
                <c:pt idx="17">
                  <c:v>62</c:v>
                </c:pt>
                <c:pt idx="18">
                  <c:v>60</c:v>
                </c:pt>
                <c:pt idx="19">
                  <c:v>56.5</c:v>
                </c:pt>
                <c:pt idx="20">
                  <c:v>48.5</c:v>
                </c:pt>
                <c:pt idx="21">
                  <c:v>43.000000000000007</c:v>
                </c:pt>
                <c:pt idx="22">
                  <c:v>35</c:v>
                </c:pt>
                <c:pt idx="23">
                  <c:v>22</c:v>
                </c:pt>
                <c:pt idx="24">
                  <c:v>13</c:v>
                </c:pt>
                <c:pt idx="25">
                  <c:v>9</c:v>
                </c:pt>
                <c:pt idx="26">
                  <c:v>2.5</c:v>
                </c:pt>
                <c:pt idx="27">
                  <c:v>1</c:v>
                </c:pt>
                <c:pt idx="28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F80-423A-900D-88AE657BB472}"/>
            </c:ext>
          </c:extLst>
        </c:ser>
        <c:ser>
          <c:idx val="1"/>
          <c:order val="1"/>
          <c:tx>
            <c:strRef>
              <c:f>'w1118 M Orotat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w1118 M Orotat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w1118 M Orotate'!$B$73:$AJ$73</c:f>
              <c:numCache>
                <c:formatCode>General</c:formatCode>
                <c:ptCount val="35"/>
                <c:pt idx="0">
                  <c:v>100</c:v>
                </c:pt>
                <c:pt idx="1">
                  <c:v>99.5</c:v>
                </c:pt>
                <c:pt idx="2">
                  <c:v>99</c:v>
                </c:pt>
                <c:pt idx="3">
                  <c:v>98</c:v>
                </c:pt>
                <c:pt idx="4">
                  <c:v>97.5</c:v>
                </c:pt>
                <c:pt idx="5">
                  <c:v>97</c:v>
                </c:pt>
                <c:pt idx="6">
                  <c:v>97</c:v>
                </c:pt>
                <c:pt idx="7">
                  <c:v>97</c:v>
                </c:pt>
                <c:pt idx="8">
                  <c:v>96</c:v>
                </c:pt>
                <c:pt idx="9">
                  <c:v>96</c:v>
                </c:pt>
                <c:pt idx="10">
                  <c:v>96</c:v>
                </c:pt>
                <c:pt idx="11">
                  <c:v>95.5</c:v>
                </c:pt>
                <c:pt idx="12">
                  <c:v>95.5</c:v>
                </c:pt>
                <c:pt idx="13">
                  <c:v>94</c:v>
                </c:pt>
                <c:pt idx="14">
                  <c:v>91.5</c:v>
                </c:pt>
                <c:pt idx="15">
                  <c:v>90</c:v>
                </c:pt>
                <c:pt idx="16">
                  <c:v>89</c:v>
                </c:pt>
                <c:pt idx="17">
                  <c:v>87</c:v>
                </c:pt>
                <c:pt idx="18">
                  <c:v>85.5</c:v>
                </c:pt>
                <c:pt idx="19">
                  <c:v>81.5</c:v>
                </c:pt>
                <c:pt idx="20">
                  <c:v>73</c:v>
                </c:pt>
                <c:pt idx="21">
                  <c:v>70.5</c:v>
                </c:pt>
                <c:pt idx="22">
                  <c:v>65.5</c:v>
                </c:pt>
                <c:pt idx="23">
                  <c:v>56.5</c:v>
                </c:pt>
                <c:pt idx="24">
                  <c:v>46.5</c:v>
                </c:pt>
                <c:pt idx="25">
                  <c:v>40</c:v>
                </c:pt>
                <c:pt idx="26">
                  <c:v>24.5</c:v>
                </c:pt>
                <c:pt idx="27">
                  <c:v>15.5</c:v>
                </c:pt>
                <c:pt idx="28">
                  <c:v>12.5</c:v>
                </c:pt>
                <c:pt idx="29">
                  <c:v>7.5</c:v>
                </c:pt>
                <c:pt idx="30">
                  <c:v>5.5</c:v>
                </c:pt>
                <c:pt idx="31">
                  <c:v>4.5</c:v>
                </c:pt>
                <c:pt idx="32">
                  <c:v>2.5</c:v>
                </c:pt>
                <c:pt idx="33">
                  <c:v>1</c:v>
                </c:pt>
                <c:pt idx="3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F80-423A-900D-88AE657BB472}"/>
            </c:ext>
          </c:extLst>
        </c:ser>
        <c:ser>
          <c:idx val="3"/>
          <c:order val="3"/>
          <c:tx>
            <c:strRef>
              <c:f>'w1118 M Orotat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w1118 M Orotate'!$B$71:$AE$71</c:f>
              <c:numCache>
                <c:formatCode>0</c:formatCode>
                <c:ptCount val="30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</c:numCache>
            </c:numRef>
          </c:cat>
          <c:val>
            <c:numRef>
              <c:f>'w1118 M Orotate'!$B$75:$I$75</c:f>
              <c:numCache>
                <c:formatCode>General</c:formatCode>
                <c:ptCount val="8"/>
                <c:pt idx="0">
                  <c:v>100</c:v>
                </c:pt>
                <c:pt idx="1">
                  <c:v>100</c:v>
                </c:pt>
                <c:pt idx="2">
                  <c:v>99</c:v>
                </c:pt>
                <c:pt idx="3">
                  <c:v>96.5</c:v>
                </c:pt>
                <c:pt idx="4">
                  <c:v>78</c:v>
                </c:pt>
                <c:pt idx="5">
                  <c:v>28.5</c:v>
                </c:pt>
                <c:pt idx="6">
                  <c:v>6</c:v>
                </c:pt>
                <c:pt idx="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F80-423A-900D-88AE657BB4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w1118 M Orotate'!$A$74</c15:sqref>
                        </c15:formulaRef>
                      </c:ext>
                    </c:extLst>
                    <c:strCache>
                      <c:ptCount val="1"/>
                      <c:pt idx="0">
                        <c:v>2 mM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w1118 M Orotate'!$B$71:$AE$71</c15:sqref>
                        </c15:formulaRef>
                      </c:ext>
                    </c:extLst>
                    <c:numCache>
                      <c:formatCode>0</c:formatCode>
                      <c:ptCount val="30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w1118 M Orotate'!$B$74:$AE$74</c15:sqref>
                        </c15:formulaRef>
                      </c:ext>
                    </c:extLst>
                    <c:numCache>
                      <c:formatCode>General</c:formatCode>
                      <c:ptCount val="30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BF80-423A-900D-88AE657BB472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anton S Males + Orotate Lifespa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anton S M Orotate'!$A$72</c:f>
              <c:strCache>
                <c:ptCount val="1"/>
                <c:pt idx="0">
                  <c:v>AL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cat>
            <c:numRef>
              <c:f>'Canton S M Orotate'!$B$71:$AJ$71</c:f>
              <c:numCache>
                <c:formatCode>0</c:formatCode>
                <c:ptCount val="35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</c:numCache>
            </c:numRef>
          </c:cat>
          <c:val>
            <c:numRef>
              <c:f>'Canton S M Orotate'!$B$72:$AF$72</c:f>
              <c:numCache>
                <c:formatCode>General</c:formatCode>
                <c:ptCount val="31"/>
                <c:pt idx="0">
                  <c:v>100</c:v>
                </c:pt>
                <c:pt idx="1">
                  <c:v>98.5</c:v>
                </c:pt>
                <c:pt idx="2">
                  <c:v>97.5</c:v>
                </c:pt>
                <c:pt idx="3">
                  <c:v>97</c:v>
                </c:pt>
                <c:pt idx="4">
                  <c:v>97</c:v>
                </c:pt>
                <c:pt idx="5">
                  <c:v>94.5</c:v>
                </c:pt>
                <c:pt idx="6">
                  <c:v>93</c:v>
                </c:pt>
                <c:pt idx="7">
                  <c:v>93</c:v>
                </c:pt>
                <c:pt idx="8">
                  <c:v>93</c:v>
                </c:pt>
                <c:pt idx="9">
                  <c:v>92.5</c:v>
                </c:pt>
                <c:pt idx="10">
                  <c:v>91.5</c:v>
                </c:pt>
                <c:pt idx="11">
                  <c:v>90</c:v>
                </c:pt>
                <c:pt idx="12">
                  <c:v>88</c:v>
                </c:pt>
                <c:pt idx="13">
                  <c:v>86</c:v>
                </c:pt>
                <c:pt idx="14">
                  <c:v>83</c:v>
                </c:pt>
                <c:pt idx="15">
                  <c:v>80</c:v>
                </c:pt>
                <c:pt idx="16">
                  <c:v>79.5</c:v>
                </c:pt>
                <c:pt idx="17">
                  <c:v>69</c:v>
                </c:pt>
                <c:pt idx="18">
                  <c:v>62.5</c:v>
                </c:pt>
                <c:pt idx="19">
                  <c:v>56.5</c:v>
                </c:pt>
                <c:pt idx="20">
                  <c:v>51.5</c:v>
                </c:pt>
                <c:pt idx="21">
                  <c:v>45.499999999999993</c:v>
                </c:pt>
                <c:pt idx="22">
                  <c:v>40</c:v>
                </c:pt>
                <c:pt idx="23">
                  <c:v>32.5</c:v>
                </c:pt>
                <c:pt idx="24">
                  <c:v>24.5</c:v>
                </c:pt>
                <c:pt idx="25">
                  <c:v>20</c:v>
                </c:pt>
                <c:pt idx="26">
                  <c:v>16</c:v>
                </c:pt>
                <c:pt idx="27">
                  <c:v>11.5</c:v>
                </c:pt>
                <c:pt idx="28">
                  <c:v>6</c:v>
                </c:pt>
                <c:pt idx="29">
                  <c:v>1</c:v>
                </c:pt>
                <c:pt idx="3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F67-40AA-A2FC-E878D120B3DD}"/>
            </c:ext>
          </c:extLst>
        </c:ser>
        <c:ser>
          <c:idx val="1"/>
          <c:order val="1"/>
          <c:tx>
            <c:strRef>
              <c:f>'Canton S M Orotate'!$A$73</c:f>
              <c:strCache>
                <c:ptCount val="1"/>
                <c:pt idx="0">
                  <c:v>DR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'Canton S M Orotate'!$B$71:$AJ$71</c:f>
              <c:numCache>
                <c:formatCode>0</c:formatCode>
                <c:ptCount val="35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</c:numCache>
            </c:numRef>
          </c:cat>
          <c:val>
            <c:numRef>
              <c:f>'Canton S M Orotate'!$B$73:$AJ$73</c:f>
              <c:numCache>
                <c:formatCode>General</c:formatCode>
                <c:ptCount val="35"/>
                <c:pt idx="0">
                  <c:v>100</c:v>
                </c:pt>
                <c:pt idx="1">
                  <c:v>99</c:v>
                </c:pt>
                <c:pt idx="2">
                  <c:v>99</c:v>
                </c:pt>
                <c:pt idx="3">
                  <c:v>99</c:v>
                </c:pt>
                <c:pt idx="4">
                  <c:v>99</c:v>
                </c:pt>
                <c:pt idx="5">
                  <c:v>99</c:v>
                </c:pt>
                <c:pt idx="6">
                  <c:v>99</c:v>
                </c:pt>
                <c:pt idx="7">
                  <c:v>99</c:v>
                </c:pt>
                <c:pt idx="8">
                  <c:v>98.5</c:v>
                </c:pt>
                <c:pt idx="9">
                  <c:v>98.5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7</c:v>
                </c:pt>
                <c:pt idx="15">
                  <c:v>95.5</c:v>
                </c:pt>
                <c:pt idx="16">
                  <c:v>95.5</c:v>
                </c:pt>
                <c:pt idx="17">
                  <c:v>94.5</c:v>
                </c:pt>
                <c:pt idx="18">
                  <c:v>91.5</c:v>
                </c:pt>
                <c:pt idx="19">
                  <c:v>90</c:v>
                </c:pt>
                <c:pt idx="20">
                  <c:v>86.5</c:v>
                </c:pt>
                <c:pt idx="21">
                  <c:v>85.5</c:v>
                </c:pt>
                <c:pt idx="22">
                  <c:v>81.5</c:v>
                </c:pt>
                <c:pt idx="23">
                  <c:v>73</c:v>
                </c:pt>
                <c:pt idx="24">
                  <c:v>66.5</c:v>
                </c:pt>
                <c:pt idx="25">
                  <c:v>63.5</c:v>
                </c:pt>
                <c:pt idx="26">
                  <c:v>51.5</c:v>
                </c:pt>
                <c:pt idx="27">
                  <c:v>45.499999999999993</c:v>
                </c:pt>
                <c:pt idx="28">
                  <c:v>41</c:v>
                </c:pt>
                <c:pt idx="29">
                  <c:v>26</c:v>
                </c:pt>
                <c:pt idx="30">
                  <c:v>20</c:v>
                </c:pt>
                <c:pt idx="31">
                  <c:v>15</c:v>
                </c:pt>
                <c:pt idx="32">
                  <c:v>7.5</c:v>
                </c:pt>
                <c:pt idx="33">
                  <c:v>1</c:v>
                </c:pt>
                <c:pt idx="3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F67-40AA-A2FC-E878D120B3DD}"/>
            </c:ext>
          </c:extLst>
        </c:ser>
        <c:ser>
          <c:idx val="3"/>
          <c:order val="3"/>
          <c:tx>
            <c:strRef>
              <c:f>'Canton S M Orotate'!$A$75</c:f>
              <c:strCache>
                <c:ptCount val="1"/>
                <c:pt idx="0">
                  <c:v>DR+10mM</c:v>
                </c:pt>
              </c:strCache>
            </c:strRef>
          </c:tx>
          <c:spPr>
            <a:ln w="285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Canton S M Orotate'!$B$71:$AJ$71</c:f>
              <c:numCache>
                <c:formatCode>0</c:formatCode>
                <c:ptCount val="35"/>
                <c:pt idx="0" formatCode="General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1</c:v>
                </c:pt>
                <c:pt idx="15">
                  <c:v>33</c:v>
                </c:pt>
                <c:pt idx="16">
                  <c:v>35</c:v>
                </c:pt>
                <c:pt idx="17">
                  <c:v>38</c:v>
                </c:pt>
                <c:pt idx="18">
                  <c:v>40</c:v>
                </c:pt>
                <c:pt idx="19">
                  <c:v>42</c:v>
                </c:pt>
                <c:pt idx="20">
                  <c:v>45</c:v>
                </c:pt>
                <c:pt idx="21">
                  <c:v>47</c:v>
                </c:pt>
                <c:pt idx="22">
                  <c:v>49</c:v>
                </c:pt>
                <c:pt idx="23">
                  <c:v>51</c:v>
                </c:pt>
                <c:pt idx="24">
                  <c:v>53</c:v>
                </c:pt>
                <c:pt idx="25">
                  <c:v>55</c:v>
                </c:pt>
                <c:pt idx="26">
                  <c:v>57</c:v>
                </c:pt>
                <c:pt idx="27">
                  <c:v>59</c:v>
                </c:pt>
                <c:pt idx="28">
                  <c:v>61</c:v>
                </c:pt>
                <c:pt idx="29">
                  <c:v>63</c:v>
                </c:pt>
                <c:pt idx="30">
                  <c:v>65</c:v>
                </c:pt>
                <c:pt idx="31">
                  <c:v>67</c:v>
                </c:pt>
                <c:pt idx="32">
                  <c:v>69</c:v>
                </c:pt>
                <c:pt idx="33">
                  <c:v>71</c:v>
                </c:pt>
                <c:pt idx="34">
                  <c:v>73</c:v>
                </c:pt>
              </c:numCache>
            </c:numRef>
          </c:cat>
          <c:val>
            <c:numRef>
              <c:f>'Canton S M Orotate'!$B$75:$K$75</c:f>
              <c:numCache>
                <c:formatCode>General</c:formatCode>
                <c:ptCount val="10"/>
                <c:pt idx="0">
                  <c:v>100</c:v>
                </c:pt>
                <c:pt idx="1">
                  <c:v>99.5</c:v>
                </c:pt>
                <c:pt idx="2">
                  <c:v>98.5</c:v>
                </c:pt>
                <c:pt idx="3">
                  <c:v>98</c:v>
                </c:pt>
                <c:pt idx="4">
                  <c:v>98</c:v>
                </c:pt>
                <c:pt idx="5">
                  <c:v>94.5</c:v>
                </c:pt>
                <c:pt idx="6">
                  <c:v>83.5</c:v>
                </c:pt>
                <c:pt idx="7">
                  <c:v>44.499999999999993</c:v>
                </c:pt>
                <c:pt idx="8">
                  <c:v>3</c:v>
                </c:pt>
                <c:pt idx="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F67-40AA-A2FC-E878D120B3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27332751"/>
        <c:axId val="2027334399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Canton S M Orotate'!$A$74</c15:sqref>
                        </c15:formulaRef>
                      </c:ext>
                    </c:extLst>
                    <c:strCache>
                      <c:ptCount val="1"/>
                      <c:pt idx="0">
                        <c:v>2 mM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prstDash val="dashDot"/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Canton S M Orotate'!$B$71:$AJ$71</c15:sqref>
                        </c15:formulaRef>
                      </c:ext>
                    </c:extLst>
                    <c:numCache>
                      <c:formatCode>0</c:formatCode>
                      <c:ptCount val="35"/>
                      <c:pt idx="0" formatCode="General">
                        <c:v>0</c:v>
                      </c:pt>
                      <c:pt idx="1">
                        <c:v>2</c:v>
                      </c:pt>
                      <c:pt idx="2">
                        <c:v>4</c:v>
                      </c:pt>
                      <c:pt idx="3">
                        <c:v>6</c:v>
                      </c:pt>
                      <c:pt idx="4">
                        <c:v>8</c:v>
                      </c:pt>
                      <c:pt idx="5">
                        <c:v>10</c:v>
                      </c:pt>
                      <c:pt idx="6">
                        <c:v>12</c:v>
                      </c:pt>
                      <c:pt idx="7">
                        <c:v>14</c:v>
                      </c:pt>
                      <c:pt idx="8">
                        <c:v>17</c:v>
                      </c:pt>
                      <c:pt idx="9">
                        <c:v>19</c:v>
                      </c:pt>
                      <c:pt idx="10">
                        <c:v>21</c:v>
                      </c:pt>
                      <c:pt idx="11">
                        <c:v>24</c:v>
                      </c:pt>
                      <c:pt idx="12">
                        <c:v>26</c:v>
                      </c:pt>
                      <c:pt idx="13">
                        <c:v>28</c:v>
                      </c:pt>
                      <c:pt idx="14">
                        <c:v>31</c:v>
                      </c:pt>
                      <c:pt idx="15">
                        <c:v>33</c:v>
                      </c:pt>
                      <c:pt idx="16">
                        <c:v>35</c:v>
                      </c:pt>
                      <c:pt idx="17">
                        <c:v>38</c:v>
                      </c:pt>
                      <c:pt idx="18">
                        <c:v>40</c:v>
                      </c:pt>
                      <c:pt idx="19">
                        <c:v>42</c:v>
                      </c:pt>
                      <c:pt idx="20">
                        <c:v>45</c:v>
                      </c:pt>
                      <c:pt idx="21">
                        <c:v>47</c:v>
                      </c:pt>
                      <c:pt idx="22">
                        <c:v>49</c:v>
                      </c:pt>
                      <c:pt idx="23">
                        <c:v>51</c:v>
                      </c:pt>
                      <c:pt idx="24">
                        <c:v>53</c:v>
                      </c:pt>
                      <c:pt idx="25">
                        <c:v>55</c:v>
                      </c:pt>
                      <c:pt idx="26">
                        <c:v>57</c:v>
                      </c:pt>
                      <c:pt idx="27">
                        <c:v>59</c:v>
                      </c:pt>
                      <c:pt idx="28">
                        <c:v>61</c:v>
                      </c:pt>
                      <c:pt idx="29">
                        <c:v>63</c:v>
                      </c:pt>
                      <c:pt idx="30">
                        <c:v>65</c:v>
                      </c:pt>
                      <c:pt idx="31">
                        <c:v>67</c:v>
                      </c:pt>
                      <c:pt idx="32">
                        <c:v>69</c:v>
                      </c:pt>
                      <c:pt idx="33">
                        <c:v>71</c:v>
                      </c:pt>
                      <c:pt idx="34">
                        <c:v>73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Canton S M Orotate'!$B$74:$AE$74</c15:sqref>
                        </c15:formulaRef>
                      </c:ext>
                    </c:extLst>
                    <c:numCache>
                      <c:formatCode>General</c:formatCode>
                      <c:ptCount val="30"/>
                      <c:pt idx="0">
                        <c:v>100</c:v>
                      </c:pt>
                      <c:pt idx="1">
                        <c:v>100</c:v>
                      </c:pt>
                      <c:pt idx="2">
                        <c:v>100</c:v>
                      </c:pt>
                      <c:pt idx="3">
                        <c:v>100</c:v>
                      </c:pt>
                      <c:pt idx="4">
                        <c:v>100</c:v>
                      </c:pt>
                      <c:pt idx="5">
                        <c:v>100</c:v>
                      </c:pt>
                      <c:pt idx="6">
                        <c:v>100</c:v>
                      </c:pt>
                      <c:pt idx="7">
                        <c:v>100</c:v>
                      </c:pt>
                      <c:pt idx="8">
                        <c:v>100</c:v>
                      </c:pt>
                      <c:pt idx="9">
                        <c:v>100</c:v>
                      </c:pt>
                      <c:pt idx="10">
                        <c:v>100</c:v>
                      </c:pt>
                      <c:pt idx="11">
                        <c:v>100</c:v>
                      </c:pt>
                      <c:pt idx="12">
                        <c:v>100</c:v>
                      </c:pt>
                      <c:pt idx="13">
                        <c:v>100</c:v>
                      </c:pt>
                      <c:pt idx="14">
                        <c:v>100</c:v>
                      </c:pt>
                      <c:pt idx="15">
                        <c:v>100</c:v>
                      </c:pt>
                      <c:pt idx="16">
                        <c:v>100</c:v>
                      </c:pt>
                      <c:pt idx="17">
                        <c:v>100</c:v>
                      </c:pt>
                      <c:pt idx="18">
                        <c:v>100</c:v>
                      </c:pt>
                      <c:pt idx="19">
                        <c:v>100</c:v>
                      </c:pt>
                      <c:pt idx="20">
                        <c:v>100</c:v>
                      </c:pt>
                      <c:pt idx="21">
                        <c:v>100</c:v>
                      </c:pt>
                      <c:pt idx="22">
                        <c:v>100</c:v>
                      </c:pt>
                      <c:pt idx="23">
                        <c:v>100</c:v>
                      </c:pt>
                      <c:pt idx="24">
                        <c:v>100</c:v>
                      </c:pt>
                      <c:pt idx="25">
                        <c:v>100</c:v>
                      </c:pt>
                      <c:pt idx="26">
                        <c:v>100</c:v>
                      </c:pt>
                      <c:pt idx="27">
                        <c:v>100</c:v>
                      </c:pt>
                      <c:pt idx="28">
                        <c:v>100</c:v>
                      </c:pt>
                      <c:pt idx="29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3-3F67-40AA-A2FC-E878D120B3DD}"/>
                  </c:ext>
                </c:extLst>
              </c15:ser>
            </c15:filteredLineSeries>
          </c:ext>
        </c:extLst>
      </c:lineChart>
      <c:catAx>
        <c:axId val="202733275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4399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202733439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73327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09BCE0-5ED2-435E-AB80-2E5E8B354315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9E23C7-1DF6-41D5-88D6-935FCF1092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461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9067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e more stringent cutoffs. Make trait nodes different color (red or pink) and scale by size. Decrease length of edges</a:t>
            </a:r>
            <a:r>
              <a:rPr lang="en-US" baseline="0" dirty="0"/>
              <a:t> connecting nodes. Do GWAS on gene by gene basis, rather than </a:t>
            </a:r>
            <a:r>
              <a:rPr lang="en-US" baseline="0"/>
              <a:t>sn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7300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e more stringent cutoffs. Make trait nodes different color (red or pink) and scale by size. Decrease length of edges</a:t>
            </a:r>
            <a:r>
              <a:rPr lang="en-US" baseline="0" dirty="0"/>
              <a:t> connecting nodes. Do GWAS on gene by gene basis, rather than </a:t>
            </a:r>
            <a:r>
              <a:rPr lang="en-US" baseline="0" dirty="0" err="1"/>
              <a:t>sn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136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e more stringent cutoffs. Make trait nodes different color (red or pink) and scale by size. Decrease length of edges</a:t>
            </a:r>
            <a:r>
              <a:rPr lang="en-US" baseline="0" dirty="0"/>
              <a:t> connecting nodes. Do GWAS on gene by gene basis, rather than </a:t>
            </a:r>
            <a:r>
              <a:rPr lang="en-US" baseline="0"/>
              <a:t>sn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4197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e more stringent cutoffs. Make trait nodes different color (red or pink) and scale by size. Decrease length of edges</a:t>
            </a:r>
            <a:r>
              <a:rPr lang="en-US" baseline="0" dirty="0"/>
              <a:t> connecting nodes. Do GWAS on gene by gene basis, rather than </a:t>
            </a:r>
            <a:r>
              <a:rPr lang="en-US" baseline="0"/>
              <a:t>sn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4603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e more stringent cutoffs. Make trait nodes different color (red or pink) and scale by size. Decrease length of edges</a:t>
            </a:r>
            <a:r>
              <a:rPr lang="en-US" baseline="0" dirty="0"/>
              <a:t> connecting nodes. Do GWAS on gene by gene basis, rather than </a:t>
            </a:r>
            <a:r>
              <a:rPr lang="en-US" baseline="0"/>
              <a:t>snp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E23C7-1DF6-41D5-88D6-935FCF1092E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7962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8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77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65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54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43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31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20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08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902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244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3"/>
            <a:ext cx="1748790" cy="85822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3"/>
            <a:ext cx="5116830" cy="85822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223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716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862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353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1"/>
            <a:ext cx="3432810" cy="6638079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1"/>
            <a:ext cx="3432810" cy="6638079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772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496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805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573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190"/>
            </a:lvl1pPr>
            <a:lvl2pPr marL="388620" indent="0">
              <a:buNone/>
              <a:defRPr sz="1020"/>
            </a:lvl2pPr>
            <a:lvl3pPr marL="777240" indent="0">
              <a:buNone/>
              <a:defRPr sz="850"/>
            </a:lvl3pPr>
            <a:lvl4pPr marL="1165860" indent="0">
              <a:buNone/>
              <a:defRPr sz="765"/>
            </a:lvl4pPr>
            <a:lvl5pPr marL="1554480" indent="0">
              <a:buNone/>
              <a:defRPr sz="765"/>
            </a:lvl5pPr>
            <a:lvl6pPr marL="1943100" indent="0">
              <a:buNone/>
              <a:defRPr sz="765"/>
            </a:lvl6pPr>
            <a:lvl7pPr marL="2331720" indent="0">
              <a:buNone/>
              <a:defRPr sz="765"/>
            </a:lvl7pPr>
            <a:lvl8pPr marL="2720340" indent="0">
              <a:buNone/>
              <a:defRPr sz="765"/>
            </a:lvl8pPr>
            <a:lvl9pPr marL="3108960" indent="0">
              <a:buNone/>
              <a:defRPr sz="76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483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190"/>
            </a:lvl1pPr>
            <a:lvl2pPr marL="388620" indent="0">
              <a:buNone/>
              <a:defRPr sz="1020"/>
            </a:lvl2pPr>
            <a:lvl3pPr marL="777240" indent="0">
              <a:buNone/>
              <a:defRPr sz="850"/>
            </a:lvl3pPr>
            <a:lvl4pPr marL="1165860" indent="0">
              <a:buNone/>
              <a:defRPr sz="765"/>
            </a:lvl4pPr>
            <a:lvl5pPr marL="1554480" indent="0">
              <a:buNone/>
              <a:defRPr sz="765"/>
            </a:lvl5pPr>
            <a:lvl6pPr marL="1943100" indent="0">
              <a:buNone/>
              <a:defRPr sz="765"/>
            </a:lvl6pPr>
            <a:lvl7pPr marL="2331720" indent="0">
              <a:buNone/>
              <a:defRPr sz="765"/>
            </a:lvl7pPr>
            <a:lvl8pPr marL="2720340" indent="0">
              <a:buNone/>
              <a:defRPr sz="765"/>
            </a:lvl8pPr>
            <a:lvl9pPr marL="3108960" indent="0">
              <a:buNone/>
              <a:defRPr sz="76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4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5B599-E21B-41B6-992B-1C3C334E7B3D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B20E65-7326-4626-9C7C-E5325A7096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09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77240" rtl="0" eaLnBrk="1" latinLnBrk="0" hangingPunct="1"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1465" indent="-291465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2720" kern="1200">
          <a:solidFill>
            <a:schemeClr val="tx1"/>
          </a:solidFill>
          <a:latin typeface="+mn-lt"/>
          <a:ea typeface="+mn-ea"/>
          <a:cs typeface="+mn-cs"/>
        </a:defRPr>
      </a:lvl1pPr>
      <a:lvl2pPr marL="631508" indent="-242888" algn="l" defTabSz="777240" rtl="0" eaLnBrk="1" latinLnBrk="0" hangingPunct="1">
        <a:spcBef>
          <a:spcPct val="20000"/>
        </a:spcBef>
        <a:buFont typeface="Arial" panose="020B0604020202020204" pitchFamily="34" charset="0"/>
        <a:buChar char="–"/>
        <a:defRPr sz="238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1E3A4214-4792-4DB0-8E49-8CA28613F7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35175" y="3506"/>
            <a:ext cx="3837225" cy="268782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67F139C-7A49-4B1E-BE79-18DA418587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35174" y="2665520"/>
            <a:ext cx="3837226" cy="268782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1DAA72D-CECE-4BBB-B9C5-718EE4461E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4451" y="2665519"/>
            <a:ext cx="3807968" cy="266733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2194ACE4-2083-4246-A613-3698BF6206D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0785" y="5340860"/>
            <a:ext cx="3775415" cy="258496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6FCA69B-C7C0-4696-861F-8487DEF6A8B6}"/>
              </a:ext>
            </a:extLst>
          </p:cNvPr>
          <p:cNvSpPr txBox="1"/>
          <p:nvPr/>
        </p:nvSpPr>
        <p:spPr>
          <a:xfrm>
            <a:off x="3892420" y="-73700"/>
            <a:ext cx="282450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509E88-6B8A-44A0-AF1E-ED8062261BC4}"/>
              </a:ext>
            </a:extLst>
          </p:cNvPr>
          <p:cNvSpPr txBox="1"/>
          <p:nvPr/>
        </p:nvSpPr>
        <p:spPr>
          <a:xfrm>
            <a:off x="-43511" y="2630372"/>
            <a:ext cx="295274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CD873AF-F7B7-4575-A02E-74D43948018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4453" y="15020"/>
            <a:ext cx="3807967" cy="266733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092166A-E06A-4DF7-94F7-0837D15D8A7F}"/>
              </a:ext>
            </a:extLst>
          </p:cNvPr>
          <p:cNvSpPr txBox="1"/>
          <p:nvPr/>
        </p:nvSpPr>
        <p:spPr>
          <a:xfrm>
            <a:off x="-43511" y="-76200"/>
            <a:ext cx="290464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E94CFF-84EB-4E99-BD93-B3CDCA30AB59}"/>
              </a:ext>
            </a:extLst>
          </p:cNvPr>
          <p:cNvSpPr txBox="1"/>
          <p:nvPr/>
        </p:nvSpPr>
        <p:spPr>
          <a:xfrm>
            <a:off x="3892420" y="2580580"/>
            <a:ext cx="277640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4FED2F-9F1D-4CED-875B-65DC7F3C2E53}"/>
              </a:ext>
            </a:extLst>
          </p:cNvPr>
          <p:cNvSpPr txBox="1"/>
          <p:nvPr/>
        </p:nvSpPr>
        <p:spPr>
          <a:xfrm>
            <a:off x="-43511" y="5300563"/>
            <a:ext cx="26962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9773358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D9FF3ED-DB97-0342-9F46-34FB7427F4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0147381"/>
              </p:ext>
            </p:extLst>
          </p:nvPr>
        </p:nvGraphicFramePr>
        <p:xfrm>
          <a:off x="-152399" y="-5004"/>
          <a:ext cx="3886200" cy="24403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C42747B-D35F-1E4A-B9B2-A910568713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7759970"/>
              </p:ext>
            </p:extLst>
          </p:nvPr>
        </p:nvGraphicFramePr>
        <p:xfrm>
          <a:off x="3886201" y="-5005"/>
          <a:ext cx="3886200" cy="24403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ED2757C2-F3F0-AC46-9A0B-EB494F944C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2776165"/>
              </p:ext>
            </p:extLst>
          </p:nvPr>
        </p:nvGraphicFramePr>
        <p:xfrm>
          <a:off x="-152400" y="2206752"/>
          <a:ext cx="3886200" cy="24403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A72C651-1DE1-F36C-900B-D9C9D63432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4304697"/>
              </p:ext>
            </p:extLst>
          </p:nvPr>
        </p:nvGraphicFramePr>
        <p:xfrm>
          <a:off x="3886200" y="2206752"/>
          <a:ext cx="3886200" cy="2440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31C4BCF6-6BBB-1A4D-8A09-BF4A9C5B88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7335827"/>
              </p:ext>
            </p:extLst>
          </p:nvPr>
        </p:nvGraphicFramePr>
        <p:xfrm>
          <a:off x="-152400" y="4414305"/>
          <a:ext cx="3886200" cy="2441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C55DF20-AE9E-5F46-A8CC-BF965EC3D6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8662798"/>
              </p:ext>
            </p:extLst>
          </p:nvPr>
        </p:nvGraphicFramePr>
        <p:xfrm>
          <a:off x="3895531" y="4414305"/>
          <a:ext cx="3886200" cy="2441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55BE02CE-CDA6-7840-8990-454F349196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010569"/>
              </p:ext>
            </p:extLst>
          </p:nvPr>
        </p:nvGraphicFramePr>
        <p:xfrm>
          <a:off x="9331" y="6702552"/>
          <a:ext cx="3886200" cy="2441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399BB058-DB77-F7EE-D68B-0F14FAD4BEAD}"/>
              </a:ext>
            </a:extLst>
          </p:cNvPr>
          <p:cNvSpPr txBox="1"/>
          <p:nvPr/>
        </p:nvSpPr>
        <p:spPr>
          <a:xfrm>
            <a:off x="3876869" y="-2800"/>
            <a:ext cx="28245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0593B7-DF82-5D99-1082-A4A97A7625CB}"/>
              </a:ext>
            </a:extLst>
          </p:cNvPr>
          <p:cNvSpPr txBox="1"/>
          <p:nvPr/>
        </p:nvSpPr>
        <p:spPr>
          <a:xfrm>
            <a:off x="3876869" y="2208050"/>
            <a:ext cx="29527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0C5C4B-0825-3566-F683-E0F75700D8AA}"/>
              </a:ext>
            </a:extLst>
          </p:cNvPr>
          <p:cNvSpPr txBox="1"/>
          <p:nvPr/>
        </p:nvSpPr>
        <p:spPr>
          <a:xfrm>
            <a:off x="0" y="-2800"/>
            <a:ext cx="29046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25F983-4EDC-D372-6767-C29A5E688291}"/>
              </a:ext>
            </a:extLst>
          </p:cNvPr>
          <p:cNvSpPr txBox="1"/>
          <p:nvPr/>
        </p:nvSpPr>
        <p:spPr>
          <a:xfrm>
            <a:off x="0" y="2208050"/>
            <a:ext cx="27764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5DB197-F81D-3114-0D86-5AF9CF9CB68B}"/>
              </a:ext>
            </a:extLst>
          </p:cNvPr>
          <p:cNvSpPr txBox="1"/>
          <p:nvPr/>
        </p:nvSpPr>
        <p:spPr>
          <a:xfrm>
            <a:off x="0" y="4411913"/>
            <a:ext cx="26962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EFB6579-AFDB-BA93-0DF4-79F703FEEDF7}"/>
              </a:ext>
            </a:extLst>
          </p:cNvPr>
          <p:cNvSpPr txBox="1"/>
          <p:nvPr/>
        </p:nvSpPr>
        <p:spPr>
          <a:xfrm>
            <a:off x="3876869" y="4411913"/>
            <a:ext cx="26481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562F56-8CFA-4C38-2A68-009F75EA8BCE}"/>
              </a:ext>
            </a:extLst>
          </p:cNvPr>
          <p:cNvSpPr txBox="1"/>
          <p:nvPr/>
        </p:nvSpPr>
        <p:spPr>
          <a:xfrm>
            <a:off x="0" y="6679592"/>
            <a:ext cx="309700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8939820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399BB058-DB77-F7EE-D68B-0F14FAD4BEAD}"/>
              </a:ext>
            </a:extLst>
          </p:cNvPr>
          <p:cNvSpPr txBox="1"/>
          <p:nvPr/>
        </p:nvSpPr>
        <p:spPr>
          <a:xfrm>
            <a:off x="3876869" y="-10161"/>
            <a:ext cx="28245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0593B7-DF82-5D99-1082-A4A97A7625CB}"/>
              </a:ext>
            </a:extLst>
          </p:cNvPr>
          <p:cNvSpPr txBox="1"/>
          <p:nvPr/>
        </p:nvSpPr>
        <p:spPr>
          <a:xfrm>
            <a:off x="3876869" y="2200689"/>
            <a:ext cx="29527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0C5C4B-0825-3566-F683-E0F75700D8AA}"/>
              </a:ext>
            </a:extLst>
          </p:cNvPr>
          <p:cNvSpPr txBox="1"/>
          <p:nvPr/>
        </p:nvSpPr>
        <p:spPr>
          <a:xfrm>
            <a:off x="0" y="-10161"/>
            <a:ext cx="290464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25F983-4EDC-D372-6767-C29A5E688291}"/>
              </a:ext>
            </a:extLst>
          </p:cNvPr>
          <p:cNvSpPr txBox="1"/>
          <p:nvPr/>
        </p:nvSpPr>
        <p:spPr>
          <a:xfrm>
            <a:off x="0" y="2200689"/>
            <a:ext cx="277640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5DB197-F81D-3114-0D86-5AF9CF9CB68B}"/>
              </a:ext>
            </a:extLst>
          </p:cNvPr>
          <p:cNvSpPr txBox="1"/>
          <p:nvPr/>
        </p:nvSpPr>
        <p:spPr>
          <a:xfrm>
            <a:off x="0" y="4404552"/>
            <a:ext cx="269626" cy="3016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60" b="1" dirty="0"/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EFB6579-AFDB-BA93-0DF4-79F703FEEDF7}"/>
              </a:ext>
            </a:extLst>
          </p:cNvPr>
          <p:cNvSpPr txBox="1"/>
          <p:nvPr/>
        </p:nvSpPr>
        <p:spPr>
          <a:xfrm>
            <a:off x="3876869" y="4404552"/>
            <a:ext cx="26481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/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562F56-8CFA-4C38-2A68-009F75EA8BCE}"/>
              </a:ext>
            </a:extLst>
          </p:cNvPr>
          <p:cNvSpPr txBox="1"/>
          <p:nvPr/>
        </p:nvSpPr>
        <p:spPr>
          <a:xfrm>
            <a:off x="0" y="6672231"/>
            <a:ext cx="309700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/>
              <a:t>G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5C80D1E1-7F7E-ED1E-546B-D21C2FA243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9626" y="6672230"/>
            <a:ext cx="4683373" cy="2927108"/>
          </a:xfrm>
          <a:prstGeom prst="rect">
            <a:avLst/>
          </a:prstGeom>
        </p:spPr>
      </p:pic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3C04B19-3CCC-4479-8828-0C6D661867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7235283"/>
              </p:ext>
            </p:extLst>
          </p:nvPr>
        </p:nvGraphicFramePr>
        <p:xfrm>
          <a:off x="3876869" y="-76200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7A589BD-48C3-48CF-89DE-4A4BD96A4A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9820022"/>
              </p:ext>
            </p:extLst>
          </p:nvPr>
        </p:nvGraphicFramePr>
        <p:xfrm>
          <a:off x="9331" y="-76200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683BB558-1E4E-47AE-BE94-7F907A6BFB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0869435"/>
              </p:ext>
            </p:extLst>
          </p:nvPr>
        </p:nvGraphicFramePr>
        <p:xfrm>
          <a:off x="13997" y="2141505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D39EB128-7785-4BCB-A6A4-7E3C22DD87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3011387"/>
              </p:ext>
            </p:extLst>
          </p:nvPr>
        </p:nvGraphicFramePr>
        <p:xfrm>
          <a:off x="3900197" y="2141505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E4C136EC-B2AE-4653-9C95-73E140B2CE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947834"/>
              </p:ext>
            </p:extLst>
          </p:nvPr>
        </p:nvGraphicFramePr>
        <p:xfrm>
          <a:off x="-11664" y="4404552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1004392-1613-4EE3-BD90-BB027BA058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4882485"/>
              </p:ext>
            </p:extLst>
          </p:nvPr>
        </p:nvGraphicFramePr>
        <p:xfrm>
          <a:off x="3879202" y="4404552"/>
          <a:ext cx="3886200" cy="2322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1236482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4FAD955-359A-4679-B7A7-5AC9E33A8D40}"/>
              </a:ext>
            </a:extLst>
          </p:cNvPr>
          <p:cNvSpPr txBox="1"/>
          <p:nvPr/>
        </p:nvSpPr>
        <p:spPr>
          <a:xfrm>
            <a:off x="1592036" y="4939005"/>
            <a:ext cx="380232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821DF5-0942-4C24-A428-46C6687128E5}"/>
              </a:ext>
            </a:extLst>
          </p:cNvPr>
          <p:cNvSpPr txBox="1"/>
          <p:nvPr/>
        </p:nvSpPr>
        <p:spPr>
          <a:xfrm>
            <a:off x="5745732" y="4939005"/>
            <a:ext cx="410690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D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7E443F5-79B9-4C9A-9105-66A2C64465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" y="5191338"/>
            <a:ext cx="3765939" cy="335104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3FC1DE1-5621-4EE0-AB26-3A6AAAE163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4990" y="5191338"/>
            <a:ext cx="3756660" cy="3351047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0417C6B-E2AE-28A2-D2E0-1E09D67098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36433"/>
            <a:ext cx="5247050" cy="47282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85713CF-8328-7E22-B330-E945FEF732F8}"/>
              </a:ext>
            </a:extLst>
          </p:cNvPr>
          <p:cNvSpPr txBox="1"/>
          <p:nvPr/>
        </p:nvSpPr>
        <p:spPr>
          <a:xfrm>
            <a:off x="2208988" y="0"/>
            <a:ext cx="829073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DR &amp; A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63B984-BE70-8BC3-EC08-A9974E7BCD1E}"/>
              </a:ext>
            </a:extLst>
          </p:cNvPr>
          <p:cNvSpPr txBox="1"/>
          <p:nvPr/>
        </p:nvSpPr>
        <p:spPr>
          <a:xfrm>
            <a:off x="17355" y="97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1858D1-69A3-BF99-6493-E9D35975F4B6}"/>
              </a:ext>
            </a:extLst>
          </p:cNvPr>
          <p:cNvSpPr txBox="1"/>
          <p:nvPr/>
        </p:nvSpPr>
        <p:spPr>
          <a:xfrm>
            <a:off x="59431" y="496464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F6D6E0B-9A3D-EEB2-638A-A75DC27B4535}"/>
              </a:ext>
            </a:extLst>
          </p:cNvPr>
          <p:cNvSpPr txBox="1"/>
          <p:nvPr/>
        </p:nvSpPr>
        <p:spPr>
          <a:xfrm>
            <a:off x="4056419" y="4964642"/>
            <a:ext cx="3474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143679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90653D-A15D-440F-9E94-7FFEC58A062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0"/>
            <a:ext cx="7772400" cy="7330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3040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1C9E5A4-0524-18B6-C1EA-C98CE51E64C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7" t="-450" r="4434" b="6574"/>
          <a:stretch/>
        </p:blipFill>
        <p:spPr>
          <a:xfrm>
            <a:off x="0" y="0"/>
            <a:ext cx="7772400" cy="7533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3650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90653D-A15D-440F-9E94-7FFEC58A062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0"/>
            <a:ext cx="7772400" cy="7330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80308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AA83D67-B142-4C88-049E-434D1DDB81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6" r="2206"/>
          <a:stretch/>
        </p:blipFill>
        <p:spPr>
          <a:xfrm>
            <a:off x="0" y="0"/>
            <a:ext cx="7772400" cy="8040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96501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AA83D67-B142-4C88-049E-434D1DDB81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7" r="4537"/>
          <a:stretch/>
        </p:blipFill>
        <p:spPr>
          <a:xfrm>
            <a:off x="19050" y="0"/>
            <a:ext cx="7772400" cy="8040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98585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AA83D67-B142-4C88-049E-434D1DDB81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7" r="4537"/>
          <a:stretch/>
        </p:blipFill>
        <p:spPr>
          <a:xfrm>
            <a:off x="0" y="0"/>
            <a:ext cx="7772400" cy="8040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1194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AA83D67-B142-4C88-049E-434D1DDB81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7" r="4537"/>
          <a:stretch/>
        </p:blipFill>
        <p:spPr>
          <a:xfrm>
            <a:off x="0" y="0"/>
            <a:ext cx="7772400" cy="8040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5234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821</TotalTime>
  <Words>334</Words>
  <Application>Microsoft Office PowerPoint</Application>
  <PresentationFormat>Custom</PresentationFormat>
  <Paragraphs>75</Paragraphs>
  <Slides>11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yler Hilsabeck</dc:creator>
  <cp:lastModifiedBy>Tyler</cp:lastModifiedBy>
  <cp:revision>1171</cp:revision>
  <cp:lastPrinted>2023-07-09T20:00:46Z</cp:lastPrinted>
  <dcterms:created xsi:type="dcterms:W3CDTF">2019-08-14T21:56:42Z</dcterms:created>
  <dcterms:modified xsi:type="dcterms:W3CDTF">2023-09-19T15:12:46Z</dcterms:modified>
</cp:coreProperties>
</file>